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3.xml" ContentType="application/vnd.openxmlformats-officedocument.presentationml.notesSlide+xml"/>
  <Override PartName="/ppt/charts/chart2.xml" ContentType="application/vnd.openxmlformats-officedocument.drawingml.chart+xml"/>
  <Override PartName="/ppt/notesSlides/notesSlide4.xml" ContentType="application/vnd.openxmlformats-officedocument.presentationml.notesSlide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5.xml" ContentType="application/vnd.openxmlformats-officedocument.presentationml.notesSlide+xml"/>
  <Override PartName="/ppt/charts/chart5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6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sldIdLst>
    <p:sldId id="338" r:id="rId2"/>
    <p:sldId id="339" r:id="rId3"/>
    <p:sldId id="340" r:id="rId4"/>
    <p:sldId id="315" r:id="rId5"/>
    <p:sldId id="337" r:id="rId6"/>
    <p:sldId id="323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885" autoAdjust="0"/>
    <p:restoredTop sz="95827"/>
  </p:normalViewPr>
  <p:slideViewPr>
    <p:cSldViewPr snapToGrid="0">
      <p:cViewPr varScale="1">
        <p:scale>
          <a:sx n="69" d="100"/>
          <a:sy n="69" d="100"/>
        </p:scale>
        <p:origin x="106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ohinatahitomi\Desktop\&#35542;&#25991;&#20316;&#25104;&#29992;&#12501;&#12449;&#12452;&#12523;\&#9733;&#25237;&#31295;IJMS%20%231\revis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ohinatahitomi\Desktop\&#35542;&#25991;&#20316;&#25104;&#29992;&#12501;&#12449;&#12452;&#12523;\&#9733;&#25237;&#31295;IJMS%20%231\revise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ohinatahitomi\Desktop\&#35542;&#25991;&#20316;&#25104;&#29992;&#12501;&#12449;&#12452;&#12523;\&#35542;&#25991;Fig&#12486;&#12441;&#12540;&#12479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ohinatahitomi\Desktop\&#35542;&#25991;&#20316;&#25104;&#29992;&#12501;&#12449;&#12452;&#12523;\&#35542;&#25991;Fig&#12486;&#12441;&#12540;&#12479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ohinatahitomi\Desktop\&#35542;&#25991;&#20316;&#25104;&#29992;&#12501;&#12449;&#12452;&#12523;\&#35542;&#25991;Fig&#12486;&#12441;&#12540;&#12479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ohinatahitomi\Desktop\&#35542;&#25991;&#20316;&#25104;&#29992;&#12501;&#12449;&#12452;&#12523;\&#35542;&#25991;Fig&#12486;&#12441;&#12540;&#12479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3"/>
          <c:order val="3"/>
          <c:tx>
            <c:strRef>
              <c:f>'200218 37℃1h or4 h'!$N$26</c:f>
              <c:strCache>
                <c:ptCount val="1"/>
                <c:pt idx="0">
                  <c:v>A.V.</c:v>
                </c:pt>
              </c:strCache>
            </c:strRef>
          </c:tx>
          <c:spPr>
            <a:solidFill>
              <a:schemeClr val="bg1"/>
            </a:solidFill>
            <a:ln w="9525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D38-8B4C-AABD-E6469C1966F2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D38-8B4C-AABD-E6469C1966F2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D38-8B4C-AABD-E6469C1966F2}"/>
              </c:ext>
            </c:extLst>
          </c:dPt>
          <c:dPt>
            <c:idx val="5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D38-8B4C-AABD-E6469C1966F2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8D38-8B4C-AABD-E6469C1966F2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8D38-8B4C-AABD-E6469C1966F2}"/>
              </c:ext>
            </c:extLst>
          </c:dPt>
          <c:errBars>
            <c:errBarType val="both"/>
            <c:errValType val="cust"/>
            <c:noEndCap val="0"/>
            <c:plus>
              <c:numRef>
                <c:f>'200218 37℃1h or4 h'!$O$27:$O$34</c:f>
                <c:numCache>
                  <c:formatCode>General</c:formatCode>
                  <c:ptCount val="8"/>
                  <c:pt idx="0">
                    <c:v>0.29374116105850728</c:v>
                  </c:pt>
                  <c:pt idx="1">
                    <c:v>0.95337382140130766</c:v>
                  </c:pt>
                  <c:pt idx="2">
                    <c:v>0.7873065307320487</c:v>
                  </c:pt>
                  <c:pt idx="3">
                    <c:v>3.3275274889923918</c:v>
                  </c:pt>
                  <c:pt idx="5">
                    <c:v>12.479835209782681</c:v>
                  </c:pt>
                  <c:pt idx="6">
                    <c:v>1.6132311561996744</c:v>
                  </c:pt>
                  <c:pt idx="7">
                    <c:v>9.8974796327145693</c:v>
                  </c:pt>
                </c:numCache>
              </c:numRef>
            </c:plus>
            <c:minus>
              <c:numRef>
                <c:f>'200218 37℃1h or4 h'!$O$27:$O$34</c:f>
                <c:numCache>
                  <c:formatCode>General</c:formatCode>
                  <c:ptCount val="8"/>
                  <c:pt idx="0">
                    <c:v>0.29374116105850728</c:v>
                  </c:pt>
                  <c:pt idx="1">
                    <c:v>0.95337382140130766</c:v>
                  </c:pt>
                  <c:pt idx="2">
                    <c:v>0.7873065307320487</c:v>
                  </c:pt>
                  <c:pt idx="3">
                    <c:v>3.3275274889923918</c:v>
                  </c:pt>
                  <c:pt idx="5">
                    <c:v>12.479835209782681</c:v>
                  </c:pt>
                  <c:pt idx="6">
                    <c:v>1.6132311561996744</c:v>
                  </c:pt>
                  <c:pt idx="7">
                    <c:v>9.89747963271456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200218 37℃1h or4 h'!$I$27:$J$34</c:f>
              <c:multiLvlStrCache>
                <c:ptCount val="8"/>
                <c:lvl>
                  <c:pt idx="0">
                    <c:v>PBS/EDTA</c:v>
                  </c:pt>
                  <c:pt idx="1">
                    <c:v>oxLDL20</c:v>
                  </c:pt>
                  <c:pt idx="2">
                    <c:v>1h oxLDL20/HDL20</c:v>
                  </c:pt>
                  <c:pt idx="3">
                    <c:v>4h oxLDL20/HDL20</c:v>
                  </c:pt>
                  <c:pt idx="4">
                    <c:v>PBS/EDTA</c:v>
                  </c:pt>
                  <c:pt idx="5">
                    <c:v>oxLDL20</c:v>
                  </c:pt>
                  <c:pt idx="6">
                    <c:v>1h oxLDL20/HDL20</c:v>
                  </c:pt>
                  <c:pt idx="7">
                    <c:v>4h oxLDL20/HDL20</c:v>
                  </c:pt>
                </c:lvl>
                <c:lvl>
                  <c:pt idx="0">
                    <c:v>PMA 0 nM</c:v>
                  </c:pt>
                  <c:pt idx="4">
                    <c:v>PMA 20 nM</c:v>
                  </c:pt>
                </c:lvl>
              </c:multiLvlStrCache>
            </c:multiLvlStrRef>
          </c:cat>
          <c:val>
            <c:numRef>
              <c:f>'200218 37℃1h or4 h'!$N$27:$N$34</c:f>
              <c:numCache>
                <c:formatCode>0.0</c:formatCode>
                <c:ptCount val="8"/>
                <c:pt idx="0">
                  <c:v>3.834635</c:v>
                </c:pt>
                <c:pt idx="1">
                  <c:v>24.76293166666667</c:v>
                </c:pt>
                <c:pt idx="2">
                  <c:v>17.427198333333333</c:v>
                </c:pt>
                <c:pt idx="3">
                  <c:v>14.156565000000001</c:v>
                </c:pt>
                <c:pt idx="4">
                  <c:v>18.820965000000001</c:v>
                </c:pt>
                <c:pt idx="5">
                  <c:v>48.789031666666666</c:v>
                </c:pt>
                <c:pt idx="6">
                  <c:v>36.091198333333331</c:v>
                </c:pt>
                <c:pt idx="7">
                  <c:v>29.573665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8D38-8B4C-AABD-E6469C1966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22387840"/>
        <c:axId val="1222389488"/>
      </c:barChart>
      <c:scatterChart>
        <c:scatterStyle val="lineMarker"/>
        <c:varyColors val="0"/>
        <c:ser>
          <c:idx val="0"/>
          <c:order val="0"/>
          <c:tx>
            <c:strRef>
              <c:f>'200218 37℃1h or4 h'!$K$26</c:f>
              <c:strCache>
                <c:ptCount val="1"/>
                <c:pt idx="0">
                  <c:v>#1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200218 37℃1h or4 h'!$I$27:$J$34</c:f>
              <c:multiLvlStrCache>
                <c:ptCount val="8"/>
                <c:lvl>
                  <c:pt idx="0">
                    <c:v>PBS/EDTA</c:v>
                  </c:pt>
                  <c:pt idx="1">
                    <c:v>oxLDL20</c:v>
                  </c:pt>
                  <c:pt idx="2">
                    <c:v>1h oxLDL20/HDL20</c:v>
                  </c:pt>
                  <c:pt idx="3">
                    <c:v>4h oxLDL20/HDL20</c:v>
                  </c:pt>
                  <c:pt idx="4">
                    <c:v>PBS/EDTA</c:v>
                  </c:pt>
                  <c:pt idx="5">
                    <c:v>oxLDL20</c:v>
                  </c:pt>
                  <c:pt idx="6">
                    <c:v>1h oxLDL20/HDL20</c:v>
                  </c:pt>
                  <c:pt idx="7">
                    <c:v>4h oxLDL20/HDL20</c:v>
                  </c:pt>
                </c:lvl>
                <c:lvl>
                  <c:pt idx="0">
                    <c:v>PMA 0 nM</c:v>
                  </c:pt>
                  <c:pt idx="4">
                    <c:v>PMA 20 nM</c:v>
                  </c:pt>
                </c:lvl>
              </c:multiLvlStrCache>
            </c:multiLvlStrRef>
          </c:xVal>
          <c:yVal>
            <c:numRef>
              <c:f>'200218 37℃1h or4 h'!$K$27:$K$34</c:f>
              <c:numCache>
                <c:formatCode>0.0000000</c:formatCode>
                <c:ptCount val="8"/>
                <c:pt idx="0">
                  <c:v>3.9343150000000002</c:v>
                </c:pt>
                <c:pt idx="1">
                  <c:v>24.490865000000003</c:v>
                </c:pt>
                <c:pt idx="2">
                  <c:v>16.699065000000001</c:v>
                </c:pt>
                <c:pt idx="3">
                  <c:v>17.990065000000001</c:v>
                </c:pt>
                <c:pt idx="5">
                  <c:v>58.401264999999995</c:v>
                </c:pt>
                <c:pt idx="6">
                  <c:v>36.396964999999994</c:v>
                </c:pt>
                <c:pt idx="7">
                  <c:v>37.36246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8D38-8B4C-AABD-E6469C1966F2}"/>
            </c:ext>
          </c:extLst>
        </c:ser>
        <c:ser>
          <c:idx val="1"/>
          <c:order val="1"/>
          <c:tx>
            <c:strRef>
              <c:f>'200218 37℃1h or4 h'!$L$26</c:f>
              <c:strCache>
                <c:ptCount val="1"/>
                <c:pt idx="0">
                  <c:v>#2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200218 37℃1h or4 h'!$I$27:$J$34</c:f>
              <c:multiLvlStrCache>
                <c:ptCount val="8"/>
                <c:lvl>
                  <c:pt idx="0">
                    <c:v>PBS/EDTA</c:v>
                  </c:pt>
                  <c:pt idx="1">
                    <c:v>oxLDL20</c:v>
                  </c:pt>
                  <c:pt idx="2">
                    <c:v>1h oxLDL20/HDL20</c:v>
                  </c:pt>
                  <c:pt idx="3">
                    <c:v>4h oxLDL20/HDL20</c:v>
                  </c:pt>
                  <c:pt idx="4">
                    <c:v>PBS/EDTA</c:v>
                  </c:pt>
                  <c:pt idx="5">
                    <c:v>oxLDL20</c:v>
                  </c:pt>
                  <c:pt idx="6">
                    <c:v>1h oxLDL20/HDL20</c:v>
                  </c:pt>
                  <c:pt idx="7">
                    <c:v>4h oxLDL20/HDL20</c:v>
                  </c:pt>
                </c:lvl>
                <c:lvl>
                  <c:pt idx="0">
                    <c:v>PMA 0 nM</c:v>
                  </c:pt>
                  <c:pt idx="4">
                    <c:v>PMA 20 nM</c:v>
                  </c:pt>
                </c:lvl>
              </c:multiLvlStrCache>
            </c:multiLvlStrRef>
          </c:xVal>
          <c:yVal>
            <c:numRef>
              <c:f>'200218 37℃1h or4 h'!$L$27:$L$34</c:f>
              <c:numCache>
                <c:formatCode>0.0000000</c:formatCode>
                <c:ptCount val="8"/>
                <c:pt idx="0">
                  <c:v>3.5040249999999999</c:v>
                </c:pt>
                <c:pt idx="1">
                  <c:v>23.975165000000001</c:v>
                </c:pt>
                <c:pt idx="2">
                  <c:v>17.319865</c:v>
                </c:pt>
                <c:pt idx="3">
                  <c:v>12.014764999999999</c:v>
                </c:pt>
                <c:pt idx="4">
                  <c:v>18.820965000000001</c:v>
                </c:pt>
                <c:pt idx="5">
                  <c:v>53.280764999999995</c:v>
                </c:pt>
                <c:pt idx="6">
                  <c:v>37.529665000000001</c:v>
                </c:pt>
                <c:pt idx="7">
                  <c:v>32.922264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8D38-8B4C-AABD-E6469C1966F2}"/>
            </c:ext>
          </c:extLst>
        </c:ser>
        <c:ser>
          <c:idx val="2"/>
          <c:order val="2"/>
          <c:tx>
            <c:strRef>
              <c:f>'200218 37℃1h or4 h'!$M$26</c:f>
              <c:strCache>
                <c:ptCount val="1"/>
                <c:pt idx="0">
                  <c:v>#3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200218 37℃1h or4 h'!$I$27:$J$34</c:f>
              <c:multiLvlStrCache>
                <c:ptCount val="8"/>
                <c:lvl>
                  <c:pt idx="0">
                    <c:v>PBS/EDTA</c:v>
                  </c:pt>
                  <c:pt idx="1">
                    <c:v>oxLDL20</c:v>
                  </c:pt>
                  <c:pt idx="2">
                    <c:v>1h oxLDL20/HDL20</c:v>
                  </c:pt>
                  <c:pt idx="3">
                    <c:v>4h oxLDL20/HDL20</c:v>
                  </c:pt>
                  <c:pt idx="4">
                    <c:v>PBS/EDTA</c:v>
                  </c:pt>
                  <c:pt idx="5">
                    <c:v>oxLDL20</c:v>
                  </c:pt>
                  <c:pt idx="6">
                    <c:v>1h oxLDL20/HDL20</c:v>
                  </c:pt>
                  <c:pt idx="7">
                    <c:v>4h oxLDL20/HDL20</c:v>
                  </c:pt>
                </c:lvl>
                <c:lvl>
                  <c:pt idx="0">
                    <c:v>PMA 0 nM</c:v>
                  </c:pt>
                  <c:pt idx="4">
                    <c:v>PMA 20 nM</c:v>
                  </c:pt>
                </c:lvl>
              </c:multiLvlStrCache>
            </c:multiLvlStrRef>
          </c:xVal>
          <c:yVal>
            <c:numRef>
              <c:f>'200218 37℃1h or4 h'!$M$27:$M$34</c:f>
              <c:numCache>
                <c:formatCode>0.0000000</c:formatCode>
                <c:ptCount val="8"/>
                <c:pt idx="0">
                  <c:v>4.0655649999999994</c:v>
                </c:pt>
                <c:pt idx="1">
                  <c:v>25.822765</c:v>
                </c:pt>
                <c:pt idx="2">
                  <c:v>18.262665000000002</c:v>
                </c:pt>
                <c:pt idx="3">
                  <c:v>12.464865</c:v>
                </c:pt>
                <c:pt idx="5" formatCode="General">
                  <c:v>34.685064999999994</c:v>
                </c:pt>
                <c:pt idx="6" formatCode="General">
                  <c:v>34.346964999999997</c:v>
                </c:pt>
                <c:pt idx="7" formatCode="General">
                  <c:v>18.436265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8D38-8B4C-AABD-E6469C1966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22387840"/>
        <c:axId val="1222389488"/>
      </c:scatterChart>
      <c:catAx>
        <c:axId val="122238784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222389488"/>
        <c:crosses val="autoZero"/>
        <c:auto val="1"/>
        <c:lblAlgn val="ctr"/>
        <c:lblOffset val="100"/>
        <c:noMultiLvlLbl val="0"/>
      </c:catAx>
      <c:valAx>
        <c:axId val="1222389488"/>
        <c:scaling>
          <c:orientation val="minMax"/>
          <c:max val="100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ＭＳ Ｐゴシック" panose="020B0600070205080204" pitchFamily="34" charset="-128"/>
                <a:ea typeface="+mn-ea"/>
                <a:cs typeface="+mn-cs"/>
              </a:defRPr>
            </a:pPr>
            <a:endParaRPr lang="ja-JP"/>
          </a:p>
        </c:txPr>
        <c:crossAx val="12223878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3"/>
          <c:order val="3"/>
          <c:tx>
            <c:strRef>
              <c:f>'221028 HDL単独（P127AtRA）'!$L$27</c:f>
              <c:strCache>
                <c:ptCount val="1"/>
                <c:pt idx="0">
                  <c:v>AV</c:v>
                </c:pt>
              </c:strCache>
            </c:strRef>
          </c:tx>
          <c:spPr>
            <a:solidFill>
              <a:schemeClr val="bg1"/>
            </a:solidFill>
            <a:ln w="9525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0A7-DA44-A8E8-A120CDE59A6D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2"/>
              </a:solidFill>
              <a:ln w="952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0A7-DA44-A8E8-A120CDE59A6D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0A7-DA44-A8E8-A120CDE59A6D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/>
              </a:solidFill>
              <a:ln w="952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0A7-DA44-A8E8-A120CDE59A6D}"/>
              </c:ext>
            </c:extLst>
          </c:dPt>
          <c:errBars>
            <c:errBarType val="both"/>
            <c:errValType val="cust"/>
            <c:noEndCap val="0"/>
            <c:plus>
              <c:numRef>
                <c:f>'221028 HDL単独（P127AtRA）'!$M$28:$M$33</c:f>
                <c:numCache>
                  <c:formatCode>General</c:formatCode>
                  <c:ptCount val="6"/>
                  <c:pt idx="0">
                    <c:v>0.75433938568790138</c:v>
                  </c:pt>
                  <c:pt idx="1">
                    <c:v>1.0040771207432226</c:v>
                  </c:pt>
                  <c:pt idx="2">
                    <c:v>2.0885661785381231</c:v>
                  </c:pt>
                  <c:pt idx="3">
                    <c:v>1.6782227454463035</c:v>
                  </c:pt>
                  <c:pt idx="4">
                    <c:v>2.7595974168949566</c:v>
                  </c:pt>
                  <c:pt idx="5">
                    <c:v>5.0396872961854813</c:v>
                  </c:pt>
                </c:numCache>
              </c:numRef>
            </c:plus>
            <c:minus>
              <c:numRef>
                <c:f>'221028 HDL単独（P127AtRA）'!$M$28:$M$33</c:f>
                <c:numCache>
                  <c:formatCode>General</c:formatCode>
                  <c:ptCount val="6"/>
                  <c:pt idx="0">
                    <c:v>0.75433938568790138</c:v>
                  </c:pt>
                  <c:pt idx="1">
                    <c:v>1.0040771207432226</c:v>
                  </c:pt>
                  <c:pt idx="2">
                    <c:v>2.0885661785381231</c:v>
                  </c:pt>
                  <c:pt idx="3">
                    <c:v>1.6782227454463035</c:v>
                  </c:pt>
                  <c:pt idx="4">
                    <c:v>2.7595974168949566</c:v>
                  </c:pt>
                  <c:pt idx="5">
                    <c:v>5.03968729618548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221028 HDL単独（P127AtRA）'!$G$28:$H$33</c:f>
              <c:multiLvlStrCache>
                <c:ptCount val="6"/>
                <c:lvl>
                  <c:pt idx="0">
                    <c:v>PBS</c:v>
                  </c:pt>
                  <c:pt idx="1">
                    <c:v>HDL20</c:v>
                  </c:pt>
                  <c:pt idx="2">
                    <c:v>HDL40</c:v>
                  </c:pt>
                  <c:pt idx="3">
                    <c:v>PBS</c:v>
                  </c:pt>
                  <c:pt idx="4">
                    <c:v>HDL20</c:v>
                  </c:pt>
                  <c:pt idx="5">
                    <c:v>HDL40</c:v>
                  </c:pt>
                </c:lvl>
                <c:lvl>
                  <c:pt idx="0">
                    <c:v>PMA 0 nM</c:v>
                  </c:pt>
                  <c:pt idx="3">
                    <c:v>PMA 20 nM</c:v>
                  </c:pt>
                </c:lvl>
              </c:multiLvlStrCache>
            </c:multiLvlStrRef>
          </c:cat>
          <c:val>
            <c:numRef>
              <c:f>'221028 HDL単独（P127AtRA）'!$L$28:$L$33</c:f>
              <c:numCache>
                <c:formatCode>0.0</c:formatCode>
                <c:ptCount val="6"/>
                <c:pt idx="0">
                  <c:v>10.441138</c:v>
                </c:pt>
                <c:pt idx="1">
                  <c:v>7.0017679999999993</c:v>
                </c:pt>
                <c:pt idx="2">
                  <c:v>10.861951333333332</c:v>
                </c:pt>
                <c:pt idx="3">
                  <c:v>50.606744666666678</c:v>
                </c:pt>
                <c:pt idx="4">
                  <c:v>43.759044666666661</c:v>
                </c:pt>
                <c:pt idx="5">
                  <c:v>42.444211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10A7-DA44-A8E8-A120CDE59A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7555376"/>
        <c:axId val="1"/>
      </c:barChart>
      <c:scatterChart>
        <c:scatterStyle val="lineMarker"/>
        <c:varyColors val="0"/>
        <c:ser>
          <c:idx val="0"/>
          <c:order val="0"/>
          <c:tx>
            <c:strRef>
              <c:f>'221028 HDL単独（P127AtRA）'!$I$27</c:f>
              <c:strCache>
                <c:ptCount val="1"/>
                <c:pt idx="0">
                  <c:v>#1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221028 HDL単独（P127AtRA）'!$G$28:$H$33</c:f>
              <c:multiLvlStrCache>
                <c:ptCount val="6"/>
                <c:lvl>
                  <c:pt idx="0">
                    <c:v>PBS</c:v>
                  </c:pt>
                  <c:pt idx="1">
                    <c:v>HDL20</c:v>
                  </c:pt>
                  <c:pt idx="2">
                    <c:v>HDL40</c:v>
                  </c:pt>
                  <c:pt idx="3">
                    <c:v>PBS</c:v>
                  </c:pt>
                  <c:pt idx="4">
                    <c:v>HDL20</c:v>
                  </c:pt>
                  <c:pt idx="5">
                    <c:v>HDL40</c:v>
                  </c:pt>
                </c:lvl>
                <c:lvl>
                  <c:pt idx="0">
                    <c:v>PMA 0 nM</c:v>
                  </c:pt>
                  <c:pt idx="3">
                    <c:v>PMA 20 nM</c:v>
                  </c:pt>
                </c:lvl>
              </c:multiLvlStrCache>
            </c:multiLvlStrRef>
          </c:xVal>
          <c:yVal>
            <c:numRef>
              <c:f>'221028 HDL単独（P127AtRA）'!$I$28:$I$33</c:f>
              <c:numCache>
                <c:formatCode>General</c:formatCode>
                <c:ptCount val="6"/>
                <c:pt idx="0">
                  <c:v>10.693978</c:v>
                </c:pt>
                <c:pt idx="1">
                  <c:v>6.3101880000000001</c:v>
                </c:pt>
                <c:pt idx="2">
                  <c:v>12.789377999999999</c:v>
                </c:pt>
                <c:pt idx="3">
                  <c:v>50.525578000000003</c:v>
                </c:pt>
                <c:pt idx="4">
                  <c:v>46.183577999999997</c:v>
                </c:pt>
                <c:pt idx="5">
                  <c:v>36.67787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10A7-DA44-A8E8-A120CDE59A6D}"/>
            </c:ext>
          </c:extLst>
        </c:ser>
        <c:ser>
          <c:idx val="1"/>
          <c:order val="1"/>
          <c:tx>
            <c:strRef>
              <c:f>'221028 HDL単独（P127AtRA）'!$J$27</c:f>
              <c:strCache>
                <c:ptCount val="1"/>
                <c:pt idx="0">
                  <c:v>#2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221028 HDL単独（P127AtRA）'!$G$28:$H$33</c:f>
              <c:multiLvlStrCache>
                <c:ptCount val="6"/>
                <c:lvl>
                  <c:pt idx="0">
                    <c:v>PBS</c:v>
                  </c:pt>
                  <c:pt idx="1">
                    <c:v>HDL20</c:v>
                  </c:pt>
                  <c:pt idx="2">
                    <c:v>HDL40</c:v>
                  </c:pt>
                  <c:pt idx="3">
                    <c:v>PBS</c:v>
                  </c:pt>
                  <c:pt idx="4">
                    <c:v>HDL20</c:v>
                  </c:pt>
                  <c:pt idx="5">
                    <c:v>HDL40</c:v>
                  </c:pt>
                </c:lvl>
                <c:lvl>
                  <c:pt idx="0">
                    <c:v>PMA 0 nM</c:v>
                  </c:pt>
                  <c:pt idx="3">
                    <c:v>PMA 20 nM</c:v>
                  </c:pt>
                </c:lvl>
              </c:multiLvlStrCache>
            </c:multiLvlStrRef>
          </c:xVal>
          <c:yVal>
            <c:numRef>
              <c:f>'221028 HDL単独（P127AtRA）'!$J$28:$J$33</c:f>
              <c:numCache>
                <c:formatCode>General</c:formatCode>
                <c:ptCount val="6"/>
                <c:pt idx="0">
                  <c:v>11.036578</c:v>
                </c:pt>
                <c:pt idx="1">
                  <c:v>8.1534479999999991</c:v>
                </c:pt>
                <c:pt idx="2">
                  <c:v>11.153578</c:v>
                </c:pt>
                <c:pt idx="3">
                  <c:v>52.324078</c:v>
                </c:pt>
                <c:pt idx="4">
                  <c:v>40.756078000000002</c:v>
                </c:pt>
                <c:pt idx="5">
                  <c:v>44.64877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10A7-DA44-A8E8-A120CDE59A6D}"/>
            </c:ext>
          </c:extLst>
        </c:ser>
        <c:ser>
          <c:idx val="2"/>
          <c:order val="2"/>
          <c:tx>
            <c:strRef>
              <c:f>'221028 HDL単独（P127AtRA）'!$K$27</c:f>
              <c:strCache>
                <c:ptCount val="1"/>
                <c:pt idx="0">
                  <c:v>#3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221028 HDL単独（P127AtRA）'!$G$28:$H$33</c:f>
              <c:multiLvlStrCache>
                <c:ptCount val="6"/>
                <c:lvl>
                  <c:pt idx="0">
                    <c:v>PBS</c:v>
                  </c:pt>
                  <c:pt idx="1">
                    <c:v>HDL20</c:v>
                  </c:pt>
                  <c:pt idx="2">
                    <c:v>HDL40</c:v>
                  </c:pt>
                  <c:pt idx="3">
                    <c:v>PBS</c:v>
                  </c:pt>
                  <c:pt idx="4">
                    <c:v>HDL20</c:v>
                  </c:pt>
                  <c:pt idx="5">
                    <c:v>HDL40</c:v>
                  </c:pt>
                </c:lvl>
                <c:lvl>
                  <c:pt idx="0">
                    <c:v>PMA 0 nM</c:v>
                  </c:pt>
                  <c:pt idx="3">
                    <c:v>PMA 20 nM</c:v>
                  </c:pt>
                </c:lvl>
              </c:multiLvlStrCache>
            </c:multiLvlStrRef>
          </c:xVal>
          <c:yVal>
            <c:numRef>
              <c:f>'221028 HDL単独（P127AtRA）'!$K$28:$K$33</c:f>
              <c:numCache>
                <c:formatCode>General</c:formatCode>
                <c:ptCount val="6"/>
                <c:pt idx="0">
                  <c:v>9.5928579999999997</c:v>
                </c:pt>
                <c:pt idx="1">
                  <c:v>6.5416679999999996</c:v>
                </c:pt>
                <c:pt idx="2">
                  <c:v>8.6428979999999989</c:v>
                </c:pt>
                <c:pt idx="3">
                  <c:v>48.970578000000003</c:v>
                </c:pt>
                <c:pt idx="4">
                  <c:v>44.337477999999997</c:v>
                </c:pt>
                <c:pt idx="5">
                  <c:v>46.005977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10A7-DA44-A8E8-A120CDE59A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37555376"/>
        <c:axId val="1"/>
      </c:scatterChart>
      <c:catAx>
        <c:axId val="113755537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"/>
        <c:crosses val="autoZero"/>
        <c:auto val="1"/>
        <c:lblAlgn val="ctr"/>
        <c:lblOffset val="100"/>
        <c:tickMarkSkip val="1"/>
        <c:noMultiLvlLbl val="0"/>
      </c:catAx>
      <c:valAx>
        <c:axId val="1"/>
        <c:scaling>
          <c:orientation val="minMax"/>
          <c:max val="100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MS UI Gothic" panose="020B0600070205080204" pitchFamily="34" charset="-128"/>
                <a:ea typeface="+mn-ea"/>
                <a:cs typeface="+mn-cs"/>
              </a:defRPr>
            </a:pPr>
            <a:endParaRPr lang="ja-JP"/>
          </a:p>
        </c:txPr>
        <c:crossAx val="1137555376"/>
        <c:crosses val="autoZero"/>
        <c:crossBetween val="between"/>
        <c:majorUnit val="1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1-B(TBARS)'!$D$48</c:f>
              <c:strCache>
                <c:ptCount val="1"/>
                <c:pt idx="0">
                  <c:v>TBARS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  <a:ln w="6350"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1-B(TBARS)'!$E$49:$E$50</c:f>
                <c:numCache>
                  <c:formatCode>General</c:formatCode>
                  <c:ptCount val="2"/>
                  <c:pt idx="0">
                    <c:v>0.37413120047917586</c:v>
                  </c:pt>
                  <c:pt idx="1">
                    <c:v>2.6003515952804532</c:v>
                  </c:pt>
                </c:numCache>
              </c:numRef>
            </c:plus>
            <c:minus>
              <c:numRef>
                <c:f>'Fig1-B(TBARS)'!$E$49:$E$50</c:f>
                <c:numCache>
                  <c:formatCode>General</c:formatCode>
                  <c:ptCount val="2"/>
                  <c:pt idx="0">
                    <c:v>0.37413120047917586</c:v>
                  </c:pt>
                  <c:pt idx="1">
                    <c:v>2.600351595280453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g1-B(TBARS)'!$C$49:$C$50</c:f>
              <c:strCache>
                <c:ptCount val="2"/>
                <c:pt idx="0">
                  <c:v>LDL</c:v>
                </c:pt>
                <c:pt idx="1">
                  <c:v>Cu-oxLDL</c:v>
                </c:pt>
              </c:strCache>
            </c:strRef>
          </c:cat>
          <c:val>
            <c:numRef>
              <c:f>'Fig1-B(TBARS)'!$D$49:$D$50</c:f>
              <c:numCache>
                <c:formatCode>0.00</c:formatCode>
                <c:ptCount val="2"/>
                <c:pt idx="0">
                  <c:v>0.65899832254972368</c:v>
                </c:pt>
                <c:pt idx="1">
                  <c:v>66.9182842080038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17-584B-8A9D-378A252DC8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71816303"/>
        <c:axId val="1072146735"/>
      </c:barChart>
      <c:catAx>
        <c:axId val="1071816303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072146735"/>
        <c:crosses val="autoZero"/>
        <c:auto val="1"/>
        <c:lblAlgn val="ctr"/>
        <c:lblOffset val="100"/>
        <c:noMultiLvlLbl val="0"/>
      </c:catAx>
      <c:valAx>
        <c:axId val="107214673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 Unicode MS" panose="020B0604020202020204" pitchFamily="34" charset="-128"/>
                <a:ea typeface="+mn-ea"/>
                <a:cs typeface="+mn-cs"/>
              </a:defRPr>
            </a:pPr>
            <a:endParaRPr lang="ja-JP"/>
          </a:p>
        </c:txPr>
        <c:crossAx val="10718163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1-B(TBARS)'!$I$48</c:f>
              <c:strCache>
                <c:ptCount val="1"/>
                <c:pt idx="0">
                  <c:v>TBARS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1-B(TBARS)'!$J$49:$J$50</c:f>
                <c:numCache>
                  <c:formatCode>General</c:formatCode>
                  <c:ptCount val="2"/>
                  <c:pt idx="0">
                    <c:v>0.37413120047917586</c:v>
                  </c:pt>
                  <c:pt idx="1">
                    <c:v>0.20753065031977877</c:v>
                  </c:pt>
                </c:numCache>
              </c:numRef>
            </c:plus>
            <c:minus>
              <c:numRef>
                <c:f>'Fig1-B(TBARS)'!$J$49:$J$50</c:f>
                <c:numCache>
                  <c:formatCode>General</c:formatCode>
                  <c:ptCount val="2"/>
                  <c:pt idx="0">
                    <c:v>0.37413120047917586</c:v>
                  </c:pt>
                  <c:pt idx="1">
                    <c:v>0.207530650319778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g1-B(TBARS)'!$H$49:$H$50</c:f>
              <c:strCache>
                <c:ptCount val="2"/>
                <c:pt idx="0">
                  <c:v>HDL</c:v>
                </c:pt>
                <c:pt idx="1">
                  <c:v>Cu-oxHDL</c:v>
                </c:pt>
              </c:strCache>
            </c:strRef>
          </c:cat>
          <c:val>
            <c:numRef>
              <c:f>'Fig1-B(TBARS)'!$I$49:$I$50</c:f>
              <c:numCache>
                <c:formatCode>0.00</c:formatCode>
                <c:ptCount val="2"/>
                <c:pt idx="0">
                  <c:v>0.95854301461778069</c:v>
                </c:pt>
                <c:pt idx="1">
                  <c:v>18.7514977234603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182-B749-BED6-1CF6356071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48061039"/>
        <c:axId val="1118675935"/>
      </c:barChart>
      <c:catAx>
        <c:axId val="104806103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118675935"/>
        <c:crosses val="autoZero"/>
        <c:auto val="1"/>
        <c:lblAlgn val="ctr"/>
        <c:lblOffset val="100"/>
        <c:noMultiLvlLbl val="0"/>
      </c:catAx>
      <c:valAx>
        <c:axId val="1118675935"/>
        <c:scaling>
          <c:orientation val="minMax"/>
          <c:max val="3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 Unicode MS" panose="020B0604020202020204" pitchFamily="34" charset="-128"/>
                <a:ea typeface="+mn-ea"/>
                <a:cs typeface="+mn-cs"/>
              </a:defRPr>
            </a:pPr>
            <a:endParaRPr lang="ja-JP"/>
          </a:p>
        </c:txPr>
        <c:crossAx val="1048061039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9"/>
          <c:order val="9"/>
          <c:tx>
            <c:strRef>
              <c:f>'Fig2-E(PAPC系)'!$V$86</c:f>
              <c:strCache>
                <c:ptCount val="1"/>
                <c:pt idx="0">
                  <c:v>AV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  <a:ln w="25400"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2-E(PAPC系)'!$W$87:$W$94</c:f>
                <c:numCache>
                  <c:formatCode>General</c:formatCode>
                  <c:ptCount val="8"/>
                  <c:pt idx="0">
                    <c:v>6.9906531788672792</c:v>
                  </c:pt>
                  <c:pt idx="1">
                    <c:v>4.3091093266260589</c:v>
                  </c:pt>
                  <c:pt idx="2">
                    <c:v>6.7094945198078735</c:v>
                  </c:pt>
                  <c:pt idx="3">
                    <c:v>9.9908558889395884</c:v>
                  </c:pt>
                  <c:pt idx="4">
                    <c:v>38.409734679352901</c:v>
                  </c:pt>
                  <c:pt idx="5">
                    <c:v>33.024727320132108</c:v>
                  </c:pt>
                  <c:pt idx="6">
                    <c:v>30.370254100744418</c:v>
                  </c:pt>
                  <c:pt idx="7">
                    <c:v>32.790601850040034</c:v>
                  </c:pt>
                </c:numCache>
              </c:numRef>
            </c:plus>
            <c:minus>
              <c:numRef>
                <c:f>'Fig2-E(PAPC系)'!$W$87:$W$94</c:f>
                <c:numCache>
                  <c:formatCode>General</c:formatCode>
                  <c:ptCount val="8"/>
                  <c:pt idx="0">
                    <c:v>6.9906531788672792</c:v>
                  </c:pt>
                  <c:pt idx="1">
                    <c:v>4.3091093266260589</c:v>
                  </c:pt>
                  <c:pt idx="2">
                    <c:v>6.7094945198078735</c:v>
                  </c:pt>
                  <c:pt idx="3">
                    <c:v>9.9908558889395884</c:v>
                  </c:pt>
                  <c:pt idx="4">
                    <c:v>38.409734679352901</c:v>
                  </c:pt>
                  <c:pt idx="5">
                    <c:v>33.024727320132108</c:v>
                  </c:pt>
                  <c:pt idx="6">
                    <c:v>30.370254100744418</c:v>
                  </c:pt>
                  <c:pt idx="7">
                    <c:v>32.7906018500400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Fig2-E(PAPC系)'!$K$87:$L$94</c:f>
              <c:multiLvlStrCache>
                <c:ptCount val="8"/>
                <c:lvl>
                  <c:pt idx="0">
                    <c:v>RPMI</c:v>
                  </c:pt>
                  <c:pt idx="1">
                    <c:v>PAPC</c:v>
                  </c:pt>
                  <c:pt idx="2">
                    <c:v>POVPC</c:v>
                  </c:pt>
                  <c:pt idx="3">
                    <c:v>PGPC</c:v>
                  </c:pt>
                  <c:pt idx="4">
                    <c:v>RPMI</c:v>
                  </c:pt>
                  <c:pt idx="5">
                    <c:v>PAPC</c:v>
                  </c:pt>
                  <c:pt idx="6">
                    <c:v>POVPC</c:v>
                  </c:pt>
                  <c:pt idx="7">
                    <c:v>PGPC</c:v>
                  </c:pt>
                </c:lvl>
                <c:lvl>
                  <c:pt idx="0">
                    <c:v>PMA 0 nM</c:v>
                  </c:pt>
                  <c:pt idx="4">
                    <c:v>PMA 50 nM</c:v>
                  </c:pt>
                </c:lvl>
              </c:multiLvlStrCache>
            </c:multiLvlStrRef>
          </c:cat>
          <c:val>
            <c:numRef>
              <c:f>'Fig2-E(PAPC系)'!$V$87:$V$94</c:f>
              <c:numCache>
                <c:formatCode>General</c:formatCode>
                <c:ptCount val="8"/>
                <c:pt idx="0">
                  <c:v>9.5900474444444441</c:v>
                </c:pt>
                <c:pt idx="1">
                  <c:v>8.1459263333333336</c:v>
                </c:pt>
                <c:pt idx="2">
                  <c:v>9.9366830000000004</c:v>
                </c:pt>
                <c:pt idx="3">
                  <c:v>9.782500777777777</c:v>
                </c:pt>
                <c:pt idx="4">
                  <c:v>106.41130522222221</c:v>
                </c:pt>
                <c:pt idx="5">
                  <c:v>99.932982999999993</c:v>
                </c:pt>
                <c:pt idx="6">
                  <c:v>128.5297607777778</c:v>
                </c:pt>
                <c:pt idx="7">
                  <c:v>156.320316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B75-3E41-A625-9CC27E0AD9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91874383"/>
        <c:axId val="291876031"/>
      </c:barChart>
      <c:scatterChart>
        <c:scatterStyle val="lineMarker"/>
        <c:varyColors val="0"/>
        <c:ser>
          <c:idx val="0"/>
          <c:order val="0"/>
          <c:tx>
            <c:strRef>
              <c:f>'Fig2-E(PAPC系)'!$M$86</c:f>
              <c:strCache>
                <c:ptCount val="1"/>
                <c:pt idx="0">
                  <c:v>#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Fig2-E(PAPC系)'!$K$87:$L$94</c:f>
              <c:multiLvlStrCache>
                <c:ptCount val="8"/>
                <c:lvl>
                  <c:pt idx="0">
                    <c:v>RPMI</c:v>
                  </c:pt>
                  <c:pt idx="1">
                    <c:v>PAPC</c:v>
                  </c:pt>
                  <c:pt idx="2">
                    <c:v>POVPC</c:v>
                  </c:pt>
                  <c:pt idx="3">
                    <c:v>PGPC</c:v>
                  </c:pt>
                  <c:pt idx="4">
                    <c:v>RPMI</c:v>
                  </c:pt>
                  <c:pt idx="5">
                    <c:v>PAPC</c:v>
                  </c:pt>
                  <c:pt idx="6">
                    <c:v>POVPC</c:v>
                  </c:pt>
                  <c:pt idx="7">
                    <c:v>PGPC</c:v>
                  </c:pt>
                </c:lvl>
                <c:lvl>
                  <c:pt idx="0">
                    <c:v>PMA 0 nM</c:v>
                  </c:pt>
                  <c:pt idx="4">
                    <c:v>PMA 50 nM</c:v>
                  </c:pt>
                </c:lvl>
              </c:multiLvlStrCache>
            </c:multiLvlStrRef>
          </c:xVal>
          <c:yVal>
            <c:numRef>
              <c:f>'Fig2-E(PAPC系)'!$M$87:$M$94</c:f>
              <c:numCache>
                <c:formatCode>General</c:formatCode>
                <c:ptCount val="8"/>
                <c:pt idx="0">
                  <c:v>5.9466975</c:v>
                </c:pt>
                <c:pt idx="1">
                  <c:v>8.5034675000000011</c:v>
                </c:pt>
                <c:pt idx="2">
                  <c:v>5.3508575</c:v>
                </c:pt>
                <c:pt idx="3">
                  <c:v>4.5291975000000004</c:v>
                </c:pt>
                <c:pt idx="4">
                  <c:v>69.792637499999998</c:v>
                </c:pt>
                <c:pt idx="5">
                  <c:v>67.499937500000001</c:v>
                </c:pt>
                <c:pt idx="6">
                  <c:v>109.1917375</c:v>
                </c:pt>
                <c:pt idx="7">
                  <c:v>145.6067375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B75-3E41-A625-9CC27E0AD9F0}"/>
            </c:ext>
          </c:extLst>
        </c:ser>
        <c:ser>
          <c:idx val="1"/>
          <c:order val="1"/>
          <c:tx>
            <c:strRef>
              <c:f>'Fig2-E(PAPC系)'!$N$86</c:f>
              <c:strCache>
                <c:ptCount val="1"/>
                <c:pt idx="0">
                  <c:v>#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Fig2-E(PAPC系)'!$K$87:$L$94</c:f>
              <c:multiLvlStrCache>
                <c:ptCount val="8"/>
                <c:lvl>
                  <c:pt idx="0">
                    <c:v>RPMI</c:v>
                  </c:pt>
                  <c:pt idx="1">
                    <c:v>PAPC</c:v>
                  </c:pt>
                  <c:pt idx="2">
                    <c:v>POVPC</c:v>
                  </c:pt>
                  <c:pt idx="3">
                    <c:v>PGPC</c:v>
                  </c:pt>
                  <c:pt idx="4">
                    <c:v>RPMI</c:v>
                  </c:pt>
                  <c:pt idx="5">
                    <c:v>PAPC</c:v>
                  </c:pt>
                  <c:pt idx="6">
                    <c:v>POVPC</c:v>
                  </c:pt>
                  <c:pt idx="7">
                    <c:v>PGPC</c:v>
                  </c:pt>
                </c:lvl>
                <c:lvl>
                  <c:pt idx="0">
                    <c:v>PMA 0 nM</c:v>
                  </c:pt>
                  <c:pt idx="4">
                    <c:v>PMA 50 nM</c:v>
                  </c:pt>
                </c:lvl>
              </c:multiLvlStrCache>
            </c:multiLvlStrRef>
          </c:xVal>
          <c:yVal>
            <c:numRef>
              <c:f>'Fig2-E(PAPC系)'!$N$87:$N$94</c:f>
              <c:numCache>
                <c:formatCode>General</c:formatCode>
                <c:ptCount val="8"/>
                <c:pt idx="0">
                  <c:v>4.7405775000000006</c:v>
                </c:pt>
                <c:pt idx="1">
                  <c:v>5.6007275000000005</c:v>
                </c:pt>
                <c:pt idx="2">
                  <c:v>9.6392375000000001</c:v>
                </c:pt>
                <c:pt idx="3">
                  <c:v>4.1868375000000002</c:v>
                </c:pt>
                <c:pt idx="4">
                  <c:v>81.3359375</c:v>
                </c:pt>
                <c:pt idx="5">
                  <c:v>79.280337500000002</c:v>
                </c:pt>
                <c:pt idx="6">
                  <c:v>114.7607375</c:v>
                </c:pt>
                <c:pt idx="7">
                  <c:v>151.7637374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B75-3E41-A625-9CC27E0AD9F0}"/>
            </c:ext>
          </c:extLst>
        </c:ser>
        <c:ser>
          <c:idx val="2"/>
          <c:order val="2"/>
          <c:tx>
            <c:strRef>
              <c:f>'Fig2-E(PAPC系)'!$O$86</c:f>
              <c:strCache>
                <c:ptCount val="1"/>
                <c:pt idx="0">
                  <c:v>#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Fig2-E(PAPC系)'!$K$87:$L$94</c:f>
              <c:multiLvlStrCache>
                <c:ptCount val="8"/>
                <c:lvl>
                  <c:pt idx="0">
                    <c:v>RPMI</c:v>
                  </c:pt>
                  <c:pt idx="1">
                    <c:v>PAPC</c:v>
                  </c:pt>
                  <c:pt idx="2">
                    <c:v>POVPC</c:v>
                  </c:pt>
                  <c:pt idx="3">
                    <c:v>PGPC</c:v>
                  </c:pt>
                  <c:pt idx="4">
                    <c:v>RPMI</c:v>
                  </c:pt>
                  <c:pt idx="5">
                    <c:v>PAPC</c:v>
                  </c:pt>
                  <c:pt idx="6">
                    <c:v>POVPC</c:v>
                  </c:pt>
                  <c:pt idx="7">
                    <c:v>PGPC</c:v>
                  </c:pt>
                </c:lvl>
                <c:lvl>
                  <c:pt idx="0">
                    <c:v>PMA 0 nM</c:v>
                  </c:pt>
                  <c:pt idx="4">
                    <c:v>PMA 50 nM</c:v>
                  </c:pt>
                </c:lvl>
              </c:multiLvlStrCache>
            </c:multiLvlStrRef>
          </c:xVal>
          <c:yVal>
            <c:numRef>
              <c:f>'Fig2-E(PAPC系)'!$O$87:$O$94</c:f>
              <c:numCache>
                <c:formatCode>General</c:formatCode>
                <c:ptCount val="8"/>
                <c:pt idx="0">
                  <c:v>3.8695075000000001</c:v>
                </c:pt>
                <c:pt idx="1">
                  <c:v>5.0699975000000004</c:v>
                </c:pt>
                <c:pt idx="2">
                  <c:v>9.3199474999999996</c:v>
                </c:pt>
                <c:pt idx="3">
                  <c:v>3.9561875000000004</c:v>
                </c:pt>
                <c:pt idx="4">
                  <c:v>82.606437499999998</c:v>
                </c:pt>
                <c:pt idx="5">
                  <c:v>66.980837500000007</c:v>
                </c:pt>
                <c:pt idx="6">
                  <c:v>120.68373750000001</c:v>
                </c:pt>
                <c:pt idx="7">
                  <c:v>161.0537375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B75-3E41-A625-9CC27E0AD9F0}"/>
            </c:ext>
          </c:extLst>
        </c:ser>
        <c:ser>
          <c:idx val="3"/>
          <c:order val="3"/>
          <c:tx>
            <c:strRef>
              <c:f>'Fig2-E(PAPC系)'!$P$86</c:f>
              <c:strCache>
                <c:ptCount val="1"/>
                <c:pt idx="0">
                  <c:v>#4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Fig2-E(PAPC系)'!$K$87:$L$94</c:f>
              <c:multiLvlStrCache>
                <c:ptCount val="8"/>
                <c:lvl>
                  <c:pt idx="0">
                    <c:v>RPMI</c:v>
                  </c:pt>
                  <c:pt idx="1">
                    <c:v>PAPC</c:v>
                  </c:pt>
                  <c:pt idx="2">
                    <c:v>POVPC</c:v>
                  </c:pt>
                  <c:pt idx="3">
                    <c:v>PGPC</c:v>
                  </c:pt>
                  <c:pt idx="4">
                    <c:v>RPMI</c:v>
                  </c:pt>
                  <c:pt idx="5">
                    <c:v>PAPC</c:v>
                  </c:pt>
                  <c:pt idx="6">
                    <c:v>POVPC</c:v>
                  </c:pt>
                  <c:pt idx="7">
                    <c:v>PGPC</c:v>
                  </c:pt>
                </c:lvl>
                <c:lvl>
                  <c:pt idx="0">
                    <c:v>PMA 0 nM</c:v>
                  </c:pt>
                  <c:pt idx="4">
                    <c:v>PMA 50 nM</c:v>
                  </c:pt>
                </c:lvl>
              </c:multiLvlStrCache>
            </c:multiLvlStrRef>
          </c:xVal>
          <c:yVal>
            <c:numRef>
              <c:f>'Fig2-E(PAPC系)'!$P$87:$P$94</c:f>
              <c:numCache>
                <c:formatCode>General</c:formatCode>
                <c:ptCount val="8"/>
                <c:pt idx="0">
                  <c:v>22.082144499999998</c:v>
                </c:pt>
                <c:pt idx="1">
                  <c:v>11.6492445</c:v>
                </c:pt>
                <c:pt idx="2">
                  <c:v>21.054644499999998</c:v>
                </c:pt>
                <c:pt idx="3">
                  <c:v>30.721344499999997</c:v>
                </c:pt>
                <c:pt idx="4">
                  <c:v>157.88404450000002</c:v>
                </c:pt>
                <c:pt idx="5">
                  <c:v>143.2020445</c:v>
                </c:pt>
                <c:pt idx="6">
                  <c:v>172.09304450000002</c:v>
                </c:pt>
                <c:pt idx="7">
                  <c:v>197.43404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5B75-3E41-A625-9CC27E0AD9F0}"/>
            </c:ext>
          </c:extLst>
        </c:ser>
        <c:ser>
          <c:idx val="4"/>
          <c:order val="4"/>
          <c:tx>
            <c:strRef>
              <c:f>'Fig2-E(PAPC系)'!$Q$86</c:f>
              <c:strCache>
                <c:ptCount val="1"/>
                <c:pt idx="0">
                  <c:v>#5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Fig2-E(PAPC系)'!$K$87:$L$94</c:f>
              <c:multiLvlStrCache>
                <c:ptCount val="8"/>
                <c:lvl>
                  <c:pt idx="0">
                    <c:v>RPMI</c:v>
                  </c:pt>
                  <c:pt idx="1">
                    <c:v>PAPC</c:v>
                  </c:pt>
                  <c:pt idx="2">
                    <c:v>POVPC</c:v>
                  </c:pt>
                  <c:pt idx="3">
                    <c:v>PGPC</c:v>
                  </c:pt>
                  <c:pt idx="4">
                    <c:v>RPMI</c:v>
                  </c:pt>
                  <c:pt idx="5">
                    <c:v>PAPC</c:v>
                  </c:pt>
                  <c:pt idx="6">
                    <c:v>POVPC</c:v>
                  </c:pt>
                  <c:pt idx="7">
                    <c:v>PGPC</c:v>
                  </c:pt>
                </c:lvl>
                <c:lvl>
                  <c:pt idx="0">
                    <c:v>PMA 0 nM</c:v>
                  </c:pt>
                  <c:pt idx="4">
                    <c:v>PMA 50 nM</c:v>
                  </c:pt>
                </c:lvl>
              </c:multiLvlStrCache>
            </c:multiLvlStrRef>
          </c:xVal>
          <c:yVal>
            <c:numRef>
              <c:f>'Fig2-E(PAPC系)'!$Q$87:$Q$94</c:f>
              <c:numCache>
                <c:formatCode>General</c:formatCode>
                <c:ptCount val="8"/>
                <c:pt idx="0">
                  <c:v>16.430944499999999</c:v>
                </c:pt>
                <c:pt idx="1">
                  <c:v>14.881944500000001</c:v>
                </c:pt>
                <c:pt idx="2">
                  <c:v>16.696844499999997</c:v>
                </c:pt>
                <c:pt idx="3">
                  <c:v>23.097944499999997</c:v>
                </c:pt>
                <c:pt idx="4">
                  <c:v>158.75904450000002</c:v>
                </c:pt>
                <c:pt idx="5">
                  <c:v>142.58104450000002</c:v>
                </c:pt>
                <c:pt idx="6">
                  <c:v>169.82304450000001</c:v>
                </c:pt>
                <c:pt idx="7">
                  <c:v>191.8540445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5B75-3E41-A625-9CC27E0AD9F0}"/>
            </c:ext>
          </c:extLst>
        </c:ser>
        <c:ser>
          <c:idx val="5"/>
          <c:order val="5"/>
          <c:tx>
            <c:strRef>
              <c:f>'Fig2-E(PAPC系)'!$R$86</c:f>
              <c:strCache>
                <c:ptCount val="1"/>
                <c:pt idx="0">
                  <c:v>#6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Fig2-E(PAPC系)'!$K$87:$L$94</c:f>
              <c:multiLvlStrCache>
                <c:ptCount val="8"/>
                <c:lvl>
                  <c:pt idx="0">
                    <c:v>RPMI</c:v>
                  </c:pt>
                  <c:pt idx="1">
                    <c:v>PAPC</c:v>
                  </c:pt>
                  <c:pt idx="2">
                    <c:v>POVPC</c:v>
                  </c:pt>
                  <c:pt idx="3">
                    <c:v>PGPC</c:v>
                  </c:pt>
                  <c:pt idx="4">
                    <c:v>RPMI</c:v>
                  </c:pt>
                  <c:pt idx="5">
                    <c:v>PAPC</c:v>
                  </c:pt>
                  <c:pt idx="6">
                    <c:v>POVPC</c:v>
                  </c:pt>
                  <c:pt idx="7">
                    <c:v>PGPC</c:v>
                  </c:pt>
                </c:lvl>
                <c:lvl>
                  <c:pt idx="0">
                    <c:v>PMA 0 nM</c:v>
                  </c:pt>
                  <c:pt idx="4">
                    <c:v>PMA 50 nM</c:v>
                  </c:pt>
                </c:lvl>
              </c:multiLvlStrCache>
            </c:multiLvlStrRef>
          </c:xVal>
          <c:yVal>
            <c:numRef>
              <c:f>'Fig2-E(PAPC系)'!$R$87:$R$94</c:f>
              <c:numCache>
                <c:formatCode>General</c:formatCode>
                <c:ptCount val="8"/>
                <c:pt idx="0">
                  <c:v>17.444744499999999</c:v>
                </c:pt>
                <c:pt idx="1">
                  <c:v>14.0662445</c:v>
                </c:pt>
                <c:pt idx="2">
                  <c:v>16.750944499999999</c:v>
                </c:pt>
                <c:pt idx="3">
                  <c:v>8.2089445000000012</c:v>
                </c:pt>
                <c:pt idx="4">
                  <c:v>154.6070445</c:v>
                </c:pt>
                <c:pt idx="5">
                  <c:v>142.96604450000001</c:v>
                </c:pt>
                <c:pt idx="6">
                  <c:v>162.2560445</c:v>
                </c:pt>
                <c:pt idx="7">
                  <c:v>197.1800445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5B75-3E41-A625-9CC27E0AD9F0}"/>
            </c:ext>
          </c:extLst>
        </c:ser>
        <c:ser>
          <c:idx val="6"/>
          <c:order val="6"/>
          <c:tx>
            <c:strRef>
              <c:f>'Fig2-E(PAPC系)'!$S$86</c:f>
              <c:strCache>
                <c:ptCount val="1"/>
                <c:pt idx="0">
                  <c:v>#7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Fig2-E(PAPC系)'!$K$87:$L$94</c:f>
              <c:multiLvlStrCache>
                <c:ptCount val="8"/>
                <c:lvl>
                  <c:pt idx="0">
                    <c:v>RPMI</c:v>
                  </c:pt>
                  <c:pt idx="1">
                    <c:v>PAPC</c:v>
                  </c:pt>
                  <c:pt idx="2">
                    <c:v>POVPC</c:v>
                  </c:pt>
                  <c:pt idx="3">
                    <c:v>PGPC</c:v>
                  </c:pt>
                  <c:pt idx="4">
                    <c:v>RPMI</c:v>
                  </c:pt>
                  <c:pt idx="5">
                    <c:v>PAPC</c:v>
                  </c:pt>
                  <c:pt idx="6">
                    <c:v>POVPC</c:v>
                  </c:pt>
                  <c:pt idx="7">
                    <c:v>PGPC</c:v>
                  </c:pt>
                </c:lvl>
                <c:lvl>
                  <c:pt idx="0">
                    <c:v>PMA 0 nM</c:v>
                  </c:pt>
                  <c:pt idx="4">
                    <c:v>PMA 50 nM</c:v>
                  </c:pt>
                </c:lvl>
              </c:multiLvlStrCache>
            </c:multiLvlStrRef>
          </c:xVal>
          <c:yVal>
            <c:numRef>
              <c:f>'Fig2-E(PAPC系)'!$S$87:$S$94</c:f>
              <c:numCache>
                <c:formatCode>General</c:formatCode>
                <c:ptCount val="8"/>
                <c:pt idx="0">
                  <c:v>4.8653270000000006</c:v>
                </c:pt>
                <c:pt idx="1">
                  <c:v>4.8862770000000006</c:v>
                </c:pt>
                <c:pt idx="2">
                  <c:v>3.5513170000000001</c:v>
                </c:pt>
                <c:pt idx="3">
                  <c:v>5.5768770000000005</c:v>
                </c:pt>
                <c:pt idx="4">
                  <c:v>86.250966999999989</c:v>
                </c:pt>
                <c:pt idx="5">
                  <c:v>86.924666999999999</c:v>
                </c:pt>
                <c:pt idx="6">
                  <c:v>104.392167</c:v>
                </c:pt>
                <c:pt idx="7">
                  <c:v>122.3821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5B75-3E41-A625-9CC27E0AD9F0}"/>
            </c:ext>
          </c:extLst>
        </c:ser>
        <c:ser>
          <c:idx val="7"/>
          <c:order val="7"/>
          <c:tx>
            <c:strRef>
              <c:f>'Fig2-E(PAPC系)'!$T$86</c:f>
              <c:strCache>
                <c:ptCount val="1"/>
                <c:pt idx="0">
                  <c:v>#8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Fig2-E(PAPC系)'!$K$87:$L$94</c:f>
              <c:multiLvlStrCache>
                <c:ptCount val="8"/>
                <c:lvl>
                  <c:pt idx="0">
                    <c:v>RPMI</c:v>
                  </c:pt>
                  <c:pt idx="1">
                    <c:v>PAPC</c:v>
                  </c:pt>
                  <c:pt idx="2">
                    <c:v>POVPC</c:v>
                  </c:pt>
                  <c:pt idx="3">
                    <c:v>PGPC</c:v>
                  </c:pt>
                  <c:pt idx="4">
                    <c:v>RPMI</c:v>
                  </c:pt>
                  <c:pt idx="5">
                    <c:v>PAPC</c:v>
                  </c:pt>
                  <c:pt idx="6">
                    <c:v>POVPC</c:v>
                  </c:pt>
                  <c:pt idx="7">
                    <c:v>PGPC</c:v>
                  </c:pt>
                </c:lvl>
                <c:lvl>
                  <c:pt idx="0">
                    <c:v>PMA 0 nM</c:v>
                  </c:pt>
                  <c:pt idx="4">
                    <c:v>PMA 50 nM</c:v>
                  </c:pt>
                </c:lvl>
              </c:multiLvlStrCache>
            </c:multiLvlStrRef>
          </c:xVal>
          <c:yVal>
            <c:numRef>
              <c:f>'Fig2-E(PAPC系)'!$T$87:$T$94</c:f>
              <c:numCache>
                <c:formatCode>General</c:formatCode>
                <c:ptCount val="8"/>
                <c:pt idx="0">
                  <c:v>4.9454970000000005</c:v>
                </c:pt>
                <c:pt idx="1">
                  <c:v>4.3336170000000003</c:v>
                </c:pt>
                <c:pt idx="2">
                  <c:v>3.7721470000000004</c:v>
                </c:pt>
                <c:pt idx="3">
                  <c:v>4.1702570000000003</c:v>
                </c:pt>
                <c:pt idx="4">
                  <c:v>77.207566999999997</c:v>
                </c:pt>
                <c:pt idx="5">
                  <c:v>85.854966999999988</c:v>
                </c:pt>
                <c:pt idx="6">
                  <c:v>101.897167</c:v>
                </c:pt>
                <c:pt idx="7">
                  <c:v>120.962166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5B75-3E41-A625-9CC27E0AD9F0}"/>
            </c:ext>
          </c:extLst>
        </c:ser>
        <c:ser>
          <c:idx val="8"/>
          <c:order val="8"/>
          <c:tx>
            <c:strRef>
              <c:f>'Fig2-E(PAPC系)'!$U$86</c:f>
              <c:strCache>
                <c:ptCount val="1"/>
                <c:pt idx="0">
                  <c:v>#9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Fig2-E(PAPC系)'!$K$87:$L$94</c:f>
              <c:multiLvlStrCache>
                <c:ptCount val="8"/>
                <c:lvl>
                  <c:pt idx="0">
                    <c:v>RPMI</c:v>
                  </c:pt>
                  <c:pt idx="1">
                    <c:v>PAPC</c:v>
                  </c:pt>
                  <c:pt idx="2">
                    <c:v>POVPC</c:v>
                  </c:pt>
                  <c:pt idx="3">
                    <c:v>PGPC</c:v>
                  </c:pt>
                  <c:pt idx="4">
                    <c:v>RPMI</c:v>
                  </c:pt>
                  <c:pt idx="5">
                    <c:v>PAPC</c:v>
                  </c:pt>
                  <c:pt idx="6">
                    <c:v>POVPC</c:v>
                  </c:pt>
                  <c:pt idx="7">
                    <c:v>PGPC</c:v>
                  </c:pt>
                </c:lvl>
                <c:lvl>
                  <c:pt idx="0">
                    <c:v>PMA 0 nM</c:v>
                  </c:pt>
                  <c:pt idx="4">
                    <c:v>PMA 50 nM</c:v>
                  </c:pt>
                </c:lvl>
              </c:multiLvlStrCache>
            </c:multiLvlStrRef>
          </c:xVal>
          <c:yVal>
            <c:numRef>
              <c:f>'Fig2-E(PAPC系)'!$U$87:$U$94</c:f>
              <c:numCache>
                <c:formatCode>General</c:formatCode>
                <c:ptCount val="8"/>
                <c:pt idx="0">
                  <c:v>5.9849870000000003</c:v>
                </c:pt>
                <c:pt idx="1">
                  <c:v>4.3218170000000002</c:v>
                </c:pt>
                <c:pt idx="2">
                  <c:v>3.2942070000000001</c:v>
                </c:pt>
                <c:pt idx="3">
                  <c:v>3.5949169999999997</c:v>
                </c:pt>
                <c:pt idx="4">
                  <c:v>89.258066999999997</c:v>
                </c:pt>
                <c:pt idx="5">
                  <c:v>84.106966999999997</c:v>
                </c:pt>
                <c:pt idx="6">
                  <c:v>101.67016699999999</c:v>
                </c:pt>
                <c:pt idx="7">
                  <c:v>118.646166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5B75-3E41-A625-9CC27E0AD9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91874383"/>
        <c:axId val="291876031"/>
      </c:scatterChart>
      <c:catAx>
        <c:axId val="291874383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91876031"/>
        <c:crosses val="autoZero"/>
        <c:auto val="1"/>
        <c:lblAlgn val="ctr"/>
        <c:lblOffset val="100"/>
        <c:noMultiLvlLbl val="0"/>
      </c:catAx>
      <c:valAx>
        <c:axId val="291876031"/>
        <c:scaling>
          <c:orientation val="minMax"/>
          <c:max val="300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dk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ＭＳ Ｐゴシック" panose="020B0600070205080204" pitchFamily="34" charset="-128"/>
                <a:ea typeface="+mn-ea"/>
                <a:cs typeface="+mn-cs"/>
              </a:defRPr>
            </a:pPr>
            <a:endParaRPr lang="ja-JP"/>
          </a:p>
        </c:txPr>
        <c:crossAx val="29187438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8"/>
          <c:order val="8"/>
          <c:tx>
            <c:strRef>
              <c:f>'Fig2-F(PLPC)(2)'!$L$3</c:f>
              <c:strCache>
                <c:ptCount val="1"/>
                <c:pt idx="0">
                  <c:v>AV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  <a:ln w="25400"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2-F(PLPC)(2)'!$M$4:$M$9</c:f>
                <c:numCache>
                  <c:formatCode>General</c:formatCode>
                  <c:ptCount val="6"/>
                  <c:pt idx="0">
                    <c:v>5.9668230043509176</c:v>
                  </c:pt>
                  <c:pt idx="1">
                    <c:v>9.227723556940477</c:v>
                  </c:pt>
                  <c:pt idx="2">
                    <c:v>19.742165757066068</c:v>
                  </c:pt>
                  <c:pt idx="3">
                    <c:v>25.718207038494921</c:v>
                  </c:pt>
                  <c:pt idx="4">
                    <c:v>23.787696583868154</c:v>
                  </c:pt>
                  <c:pt idx="5">
                    <c:v>16.237209358448879</c:v>
                  </c:pt>
                </c:numCache>
              </c:numRef>
            </c:plus>
            <c:minus>
              <c:numRef>
                <c:f>'Fig2-F(PLPC)(2)'!$M$4:$M$9</c:f>
                <c:numCache>
                  <c:formatCode>General</c:formatCode>
                  <c:ptCount val="6"/>
                  <c:pt idx="0">
                    <c:v>5.9668230043509176</c:v>
                  </c:pt>
                  <c:pt idx="1">
                    <c:v>9.227723556940477</c:v>
                  </c:pt>
                  <c:pt idx="2">
                    <c:v>19.742165757066068</c:v>
                  </c:pt>
                  <c:pt idx="3">
                    <c:v>25.718207038494921</c:v>
                  </c:pt>
                  <c:pt idx="4">
                    <c:v>23.787696583868154</c:v>
                  </c:pt>
                  <c:pt idx="5">
                    <c:v>16.23720935844887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Fig2-F(PLPC)(2)'!$B$4:$C$9</c:f>
              <c:multiLvlStrCache>
                <c:ptCount val="6"/>
                <c:lvl>
                  <c:pt idx="0">
                    <c:v>RPMI</c:v>
                  </c:pt>
                  <c:pt idx="1">
                    <c:v>PLPC</c:v>
                  </c:pt>
                  <c:pt idx="2">
                    <c:v>PAzPC</c:v>
                  </c:pt>
                  <c:pt idx="3">
                    <c:v>RPMI</c:v>
                  </c:pt>
                  <c:pt idx="4">
                    <c:v>PLPC</c:v>
                  </c:pt>
                  <c:pt idx="5">
                    <c:v>PAzPC</c:v>
                  </c:pt>
                </c:lvl>
                <c:lvl>
                  <c:pt idx="0">
                    <c:v>PMA 0 nM</c:v>
                  </c:pt>
                  <c:pt idx="3">
                    <c:v>PMA 50 nM</c:v>
                  </c:pt>
                </c:lvl>
              </c:multiLvlStrCache>
            </c:multiLvlStrRef>
          </c:cat>
          <c:val>
            <c:numRef>
              <c:f>'Fig2-F(PLPC)(2)'!$L$4:$L$9</c:f>
              <c:numCache>
                <c:formatCode>General</c:formatCode>
                <c:ptCount val="6"/>
                <c:pt idx="0">
                  <c:v>12.841129250000002</c:v>
                </c:pt>
                <c:pt idx="1">
                  <c:v>19.57703175</c:v>
                </c:pt>
                <c:pt idx="2">
                  <c:v>48.769894249999993</c:v>
                </c:pt>
                <c:pt idx="3">
                  <c:v>104.45541924999998</c:v>
                </c:pt>
                <c:pt idx="4">
                  <c:v>141.54023175</c:v>
                </c:pt>
                <c:pt idx="5">
                  <c:v>182.71260675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F12-4045-B27B-274B80B7D2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72125039"/>
        <c:axId val="235862591"/>
      </c:barChart>
      <c:scatterChart>
        <c:scatterStyle val="lineMarker"/>
        <c:varyColors val="0"/>
        <c:ser>
          <c:idx val="0"/>
          <c:order val="0"/>
          <c:tx>
            <c:strRef>
              <c:f>'Fig2-F(PLPC)(2)'!$D$3</c:f>
              <c:strCache>
                <c:ptCount val="1"/>
                <c:pt idx="0">
                  <c:v>#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Fig2-F(PLPC)(2)'!$B$4:$C$9</c:f>
              <c:multiLvlStrCache>
                <c:ptCount val="6"/>
                <c:lvl>
                  <c:pt idx="0">
                    <c:v>RPMI</c:v>
                  </c:pt>
                  <c:pt idx="1">
                    <c:v>PLPC</c:v>
                  </c:pt>
                  <c:pt idx="2">
                    <c:v>PAzPC</c:v>
                  </c:pt>
                  <c:pt idx="3">
                    <c:v>RPMI</c:v>
                  </c:pt>
                  <c:pt idx="4">
                    <c:v>PLPC</c:v>
                  </c:pt>
                  <c:pt idx="5">
                    <c:v>PAzPC</c:v>
                  </c:pt>
                </c:lvl>
                <c:lvl>
                  <c:pt idx="0">
                    <c:v>PMA 0 nM</c:v>
                  </c:pt>
                  <c:pt idx="3">
                    <c:v>PMA 50 nM</c:v>
                  </c:pt>
                </c:lvl>
              </c:multiLvlStrCache>
            </c:multiLvlStrRef>
          </c:xVal>
          <c:yVal>
            <c:numRef>
              <c:f>'Fig2-F(PLPC)(2)'!$D$4:$D$9</c:f>
              <c:numCache>
                <c:formatCode>General</c:formatCode>
                <c:ptCount val="6"/>
                <c:pt idx="0">
                  <c:v>8.4207964999999998</c:v>
                </c:pt>
                <c:pt idx="1">
                  <c:v>17.8170465</c:v>
                </c:pt>
                <c:pt idx="2">
                  <c:v>29.503846499999998</c:v>
                </c:pt>
                <c:pt idx="3">
                  <c:v>79.287646499999994</c:v>
                </c:pt>
                <c:pt idx="4">
                  <c:v>126.2094465</c:v>
                </c:pt>
                <c:pt idx="5">
                  <c:v>180.8214465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F12-4045-B27B-274B80B7D283}"/>
            </c:ext>
          </c:extLst>
        </c:ser>
        <c:ser>
          <c:idx val="1"/>
          <c:order val="1"/>
          <c:tx>
            <c:strRef>
              <c:f>'Fig2-F(PLPC)(2)'!$E$3</c:f>
              <c:strCache>
                <c:ptCount val="1"/>
                <c:pt idx="0">
                  <c:v>#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Fig2-F(PLPC)(2)'!$B$4:$C$9</c:f>
              <c:multiLvlStrCache>
                <c:ptCount val="6"/>
                <c:lvl>
                  <c:pt idx="0">
                    <c:v>RPMI</c:v>
                  </c:pt>
                  <c:pt idx="1">
                    <c:v>PLPC</c:v>
                  </c:pt>
                  <c:pt idx="2">
                    <c:v>PAzPC</c:v>
                  </c:pt>
                  <c:pt idx="3">
                    <c:v>RPMI</c:v>
                  </c:pt>
                  <c:pt idx="4">
                    <c:v>PLPC</c:v>
                  </c:pt>
                  <c:pt idx="5">
                    <c:v>PAzPC</c:v>
                  </c:pt>
                </c:lvl>
                <c:lvl>
                  <c:pt idx="0">
                    <c:v>PMA 0 nM</c:v>
                  </c:pt>
                  <c:pt idx="3">
                    <c:v>PMA 50 nM</c:v>
                  </c:pt>
                </c:lvl>
              </c:multiLvlStrCache>
            </c:multiLvlStrRef>
          </c:xVal>
          <c:yVal>
            <c:numRef>
              <c:f>'Fig2-F(PLPC)(2)'!$E$4:$E$9</c:f>
              <c:numCache>
                <c:formatCode>General</c:formatCode>
                <c:ptCount val="6"/>
                <c:pt idx="0">
                  <c:v>6.5805565000000001</c:v>
                </c:pt>
                <c:pt idx="1">
                  <c:v>15.257346499999999</c:v>
                </c:pt>
                <c:pt idx="2">
                  <c:v>23.8415465</c:v>
                </c:pt>
                <c:pt idx="3">
                  <c:v>77.083046499999995</c:v>
                </c:pt>
                <c:pt idx="4">
                  <c:v>124.8784465</c:v>
                </c:pt>
                <c:pt idx="5">
                  <c:v>172.0734464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F12-4045-B27B-274B80B7D283}"/>
            </c:ext>
          </c:extLst>
        </c:ser>
        <c:ser>
          <c:idx val="2"/>
          <c:order val="2"/>
          <c:tx>
            <c:strRef>
              <c:f>'Fig2-F(PLPC)(2)'!$F$3</c:f>
              <c:strCache>
                <c:ptCount val="1"/>
                <c:pt idx="0">
                  <c:v>#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Fig2-F(PLPC)(2)'!$B$4:$C$9</c:f>
              <c:multiLvlStrCache>
                <c:ptCount val="6"/>
                <c:lvl>
                  <c:pt idx="0">
                    <c:v>RPMI</c:v>
                  </c:pt>
                  <c:pt idx="1">
                    <c:v>PLPC</c:v>
                  </c:pt>
                  <c:pt idx="2">
                    <c:v>PAzPC</c:v>
                  </c:pt>
                  <c:pt idx="3">
                    <c:v>RPMI</c:v>
                  </c:pt>
                  <c:pt idx="4">
                    <c:v>PLPC</c:v>
                  </c:pt>
                  <c:pt idx="5">
                    <c:v>PAzPC</c:v>
                  </c:pt>
                </c:lvl>
                <c:lvl>
                  <c:pt idx="0">
                    <c:v>PMA 0 nM</c:v>
                  </c:pt>
                  <c:pt idx="3">
                    <c:v>PMA 50 nM</c:v>
                  </c:pt>
                </c:lvl>
              </c:multiLvlStrCache>
            </c:multiLvlStrRef>
          </c:xVal>
          <c:yVal>
            <c:numRef>
              <c:f>'Fig2-F(PLPC)(2)'!$F$4:$F$9</c:f>
              <c:numCache>
                <c:formatCode>General</c:formatCode>
                <c:ptCount val="6"/>
                <c:pt idx="0">
                  <c:v>6.4813665</c:v>
                </c:pt>
                <c:pt idx="1">
                  <c:v>11.826646499999999</c:v>
                </c:pt>
                <c:pt idx="2">
                  <c:v>43.141246500000001</c:v>
                </c:pt>
                <c:pt idx="3">
                  <c:v>72.246146499999995</c:v>
                </c:pt>
                <c:pt idx="4">
                  <c:v>119.02344649999999</c:v>
                </c:pt>
                <c:pt idx="5">
                  <c:v>187.0544464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F12-4045-B27B-274B80B7D283}"/>
            </c:ext>
          </c:extLst>
        </c:ser>
        <c:ser>
          <c:idx val="3"/>
          <c:order val="3"/>
          <c:tx>
            <c:strRef>
              <c:f>'Fig2-F(PLPC)(2)'!$G$3</c:f>
              <c:strCache>
                <c:ptCount val="1"/>
                <c:pt idx="0">
                  <c:v>#4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Fig2-F(PLPC)(2)'!$B$4:$C$9</c:f>
              <c:multiLvlStrCache>
                <c:ptCount val="6"/>
                <c:lvl>
                  <c:pt idx="0">
                    <c:v>RPMI</c:v>
                  </c:pt>
                  <c:pt idx="1">
                    <c:v>PLPC</c:v>
                  </c:pt>
                  <c:pt idx="2">
                    <c:v>PAzPC</c:v>
                  </c:pt>
                  <c:pt idx="3">
                    <c:v>RPMI</c:v>
                  </c:pt>
                  <c:pt idx="4">
                    <c:v>PLPC</c:v>
                  </c:pt>
                  <c:pt idx="5">
                    <c:v>PAzPC</c:v>
                  </c:pt>
                </c:lvl>
                <c:lvl>
                  <c:pt idx="0">
                    <c:v>PMA 0 nM</c:v>
                  </c:pt>
                  <c:pt idx="3">
                    <c:v>PMA 50 nM</c:v>
                  </c:pt>
                </c:lvl>
              </c:multiLvlStrCache>
            </c:multiLvlStrRef>
          </c:xVal>
          <c:yVal>
            <c:numRef>
              <c:f>'Fig2-F(PLPC)(2)'!$G$4:$G$9</c:f>
              <c:numCache>
                <c:formatCode>General</c:formatCode>
                <c:ptCount val="6"/>
                <c:pt idx="0">
                  <c:v>11.773908500000001</c:v>
                </c:pt>
                <c:pt idx="1">
                  <c:v>31.3827085</c:v>
                </c:pt>
                <c:pt idx="2">
                  <c:v>68.366208499999999</c:v>
                </c:pt>
                <c:pt idx="3">
                  <c:v>112.2695085</c:v>
                </c:pt>
                <c:pt idx="4">
                  <c:v>132.82850850000003</c:v>
                </c:pt>
                <c:pt idx="5">
                  <c:v>169.3895085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DF12-4045-B27B-274B80B7D283}"/>
            </c:ext>
          </c:extLst>
        </c:ser>
        <c:ser>
          <c:idx val="4"/>
          <c:order val="4"/>
          <c:tx>
            <c:strRef>
              <c:f>'Fig2-F(PLPC)(2)'!$H$3</c:f>
              <c:strCache>
                <c:ptCount val="1"/>
                <c:pt idx="0">
                  <c:v>#5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Fig2-F(PLPC)(2)'!$B$4:$C$9</c:f>
              <c:multiLvlStrCache>
                <c:ptCount val="6"/>
                <c:lvl>
                  <c:pt idx="0">
                    <c:v>RPMI</c:v>
                  </c:pt>
                  <c:pt idx="1">
                    <c:v>PLPC</c:v>
                  </c:pt>
                  <c:pt idx="2">
                    <c:v>PAzPC</c:v>
                  </c:pt>
                  <c:pt idx="3">
                    <c:v>RPMI</c:v>
                  </c:pt>
                  <c:pt idx="4">
                    <c:v>PLPC</c:v>
                  </c:pt>
                  <c:pt idx="5">
                    <c:v>PAzPC</c:v>
                  </c:pt>
                </c:lvl>
                <c:lvl>
                  <c:pt idx="0">
                    <c:v>PMA 0 nM</c:v>
                  </c:pt>
                  <c:pt idx="3">
                    <c:v>PMA 50 nM</c:v>
                  </c:pt>
                </c:lvl>
              </c:multiLvlStrCache>
            </c:multiLvlStrRef>
          </c:xVal>
          <c:yVal>
            <c:numRef>
              <c:f>'Fig2-F(PLPC)(2)'!$H$4:$H$9</c:f>
              <c:numCache>
                <c:formatCode>General</c:formatCode>
                <c:ptCount val="6"/>
                <c:pt idx="0">
                  <c:v>20.655708499999999</c:v>
                </c:pt>
                <c:pt idx="1">
                  <c:v>28.710908499999999</c:v>
                </c:pt>
                <c:pt idx="2">
                  <c:v>55.876708499999999</c:v>
                </c:pt>
                <c:pt idx="3">
                  <c:v>111.06550849999999</c:v>
                </c:pt>
                <c:pt idx="4">
                  <c:v>136.0435085</c:v>
                </c:pt>
                <c:pt idx="5">
                  <c:v>168.0895085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DF12-4045-B27B-274B80B7D283}"/>
            </c:ext>
          </c:extLst>
        </c:ser>
        <c:ser>
          <c:idx val="5"/>
          <c:order val="5"/>
          <c:tx>
            <c:strRef>
              <c:f>'Fig2-F(PLPC)(2)'!$I$3</c:f>
              <c:strCache>
                <c:ptCount val="1"/>
                <c:pt idx="0">
                  <c:v>#6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Fig2-F(PLPC)(2)'!$B$4:$C$9</c:f>
              <c:multiLvlStrCache>
                <c:ptCount val="6"/>
                <c:lvl>
                  <c:pt idx="0">
                    <c:v>RPMI</c:v>
                  </c:pt>
                  <c:pt idx="1">
                    <c:v>PLPC</c:v>
                  </c:pt>
                  <c:pt idx="2">
                    <c:v>PAzPC</c:v>
                  </c:pt>
                  <c:pt idx="3">
                    <c:v>RPMI</c:v>
                  </c:pt>
                  <c:pt idx="4">
                    <c:v>PLPC</c:v>
                  </c:pt>
                  <c:pt idx="5">
                    <c:v>PAzPC</c:v>
                  </c:pt>
                </c:lvl>
                <c:lvl>
                  <c:pt idx="0">
                    <c:v>PMA 0 nM</c:v>
                  </c:pt>
                  <c:pt idx="3">
                    <c:v>PMA 50 nM</c:v>
                  </c:pt>
                </c:lvl>
              </c:multiLvlStrCache>
            </c:multiLvlStrRef>
          </c:xVal>
          <c:yVal>
            <c:numRef>
              <c:f>'Fig2-F(PLPC)(2)'!$I$4:$I$9</c:f>
              <c:numCache>
                <c:formatCode>General</c:formatCode>
                <c:ptCount val="6"/>
                <c:pt idx="0">
                  <c:v>11.3749085</c:v>
                </c:pt>
                <c:pt idx="1">
                  <c:v>30.736908499999998</c:v>
                </c:pt>
                <c:pt idx="2">
                  <c:v>57.076108499999997</c:v>
                </c:pt>
                <c:pt idx="3">
                  <c:v>111.4215085</c:v>
                </c:pt>
                <c:pt idx="4">
                  <c:v>135.64050850000001</c:v>
                </c:pt>
                <c:pt idx="5">
                  <c:v>170.490508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DF12-4045-B27B-274B80B7D283}"/>
            </c:ext>
          </c:extLst>
        </c:ser>
        <c:ser>
          <c:idx val="6"/>
          <c:order val="6"/>
          <c:tx>
            <c:strRef>
              <c:f>'Fig2-F(PLPC)(2)'!$J$3</c:f>
              <c:strCache>
                <c:ptCount val="1"/>
                <c:pt idx="0">
                  <c:v>#7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Fig2-F(PLPC)(2)'!$B$4:$C$9</c:f>
              <c:multiLvlStrCache>
                <c:ptCount val="6"/>
                <c:lvl>
                  <c:pt idx="0">
                    <c:v>RPMI</c:v>
                  </c:pt>
                  <c:pt idx="1">
                    <c:v>PLPC</c:v>
                  </c:pt>
                  <c:pt idx="2">
                    <c:v>PAzPC</c:v>
                  </c:pt>
                  <c:pt idx="3">
                    <c:v>RPMI</c:v>
                  </c:pt>
                  <c:pt idx="4">
                    <c:v>PLPC</c:v>
                  </c:pt>
                  <c:pt idx="5">
                    <c:v>PAzPC</c:v>
                  </c:pt>
                </c:lvl>
                <c:lvl>
                  <c:pt idx="0">
                    <c:v>PMA 0 nM</c:v>
                  </c:pt>
                  <c:pt idx="3">
                    <c:v>PMA 50 nM</c:v>
                  </c:pt>
                </c:lvl>
              </c:multiLvlStrCache>
            </c:multiLvlStrRef>
          </c:xVal>
          <c:yVal>
            <c:numRef>
              <c:f>'Fig2-F(PLPC)(2)'!$J$4:$J$9</c:f>
              <c:numCache>
                <c:formatCode>General</c:formatCode>
                <c:ptCount val="6"/>
                <c:pt idx="0">
                  <c:v>15.8450945</c:v>
                </c:pt>
                <c:pt idx="1">
                  <c:v>10.4211945</c:v>
                </c:pt>
                <c:pt idx="2">
                  <c:v>32.823494500000002</c:v>
                </c:pt>
                <c:pt idx="3">
                  <c:v>141.10549449999999</c:v>
                </c:pt>
                <c:pt idx="4">
                  <c:v>175.97449449999999</c:v>
                </c:pt>
                <c:pt idx="5">
                  <c:v>206.9064945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DF12-4045-B27B-274B80B7D283}"/>
            </c:ext>
          </c:extLst>
        </c:ser>
        <c:ser>
          <c:idx val="7"/>
          <c:order val="7"/>
          <c:tx>
            <c:strRef>
              <c:f>'Fig2-F(PLPC)(2)'!$K$3</c:f>
              <c:strCache>
                <c:ptCount val="1"/>
                <c:pt idx="0">
                  <c:v>#8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multiLvlStrRef>
              <c:f>'Fig2-F(PLPC)(2)'!$B$4:$C$9</c:f>
              <c:multiLvlStrCache>
                <c:ptCount val="6"/>
                <c:lvl>
                  <c:pt idx="0">
                    <c:v>RPMI</c:v>
                  </c:pt>
                  <c:pt idx="1">
                    <c:v>PLPC</c:v>
                  </c:pt>
                  <c:pt idx="2">
                    <c:v>PAzPC</c:v>
                  </c:pt>
                  <c:pt idx="3">
                    <c:v>RPMI</c:v>
                  </c:pt>
                  <c:pt idx="4">
                    <c:v>PLPC</c:v>
                  </c:pt>
                  <c:pt idx="5">
                    <c:v>PAzPC</c:v>
                  </c:pt>
                </c:lvl>
                <c:lvl>
                  <c:pt idx="0">
                    <c:v>PMA 0 nM</c:v>
                  </c:pt>
                  <c:pt idx="3">
                    <c:v>PMA 50 nM</c:v>
                  </c:pt>
                </c:lvl>
              </c:multiLvlStrCache>
            </c:multiLvlStrRef>
          </c:xVal>
          <c:yVal>
            <c:numRef>
              <c:f>'Fig2-F(PLPC)(2)'!$K$4:$K$9</c:f>
              <c:numCache>
                <c:formatCode>General</c:formatCode>
                <c:ptCount val="6"/>
                <c:pt idx="0">
                  <c:v>21.596694500000002</c:v>
                </c:pt>
                <c:pt idx="1">
                  <c:v>10.463494499999999</c:v>
                </c:pt>
                <c:pt idx="2">
                  <c:v>79.529994500000001</c:v>
                </c:pt>
                <c:pt idx="3">
                  <c:v>131.16449449999999</c:v>
                </c:pt>
                <c:pt idx="4">
                  <c:v>181.72349450000002</c:v>
                </c:pt>
                <c:pt idx="5">
                  <c:v>206.87549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DF12-4045-B27B-274B80B7D2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2125039"/>
        <c:axId val="235862591"/>
      </c:scatterChart>
      <c:catAx>
        <c:axId val="27212503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35862591"/>
        <c:crosses val="autoZero"/>
        <c:auto val="1"/>
        <c:lblAlgn val="ctr"/>
        <c:lblOffset val="100"/>
        <c:noMultiLvlLbl val="0"/>
      </c:catAx>
      <c:valAx>
        <c:axId val="235862591"/>
        <c:scaling>
          <c:orientation val="minMax"/>
          <c:max val="30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ＭＳ Ｐゴシック" panose="020B0600070205080204" pitchFamily="34" charset="-128"/>
                <a:ea typeface="+mn-ea"/>
                <a:cs typeface="+mn-cs"/>
              </a:defRPr>
            </a:pPr>
            <a:endParaRPr lang="ja-JP"/>
          </a:p>
        </c:txPr>
        <c:crossAx val="2721250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CA3063-85BA-1248-BBA4-B5CAE3C7A2A4}" type="datetimeFigureOut">
              <a:rPr kumimoji="1" lang="ja-JP" altLang="en-US" smtClean="0"/>
              <a:t>2022/11/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815FFD-3D43-594E-A949-21C08EF595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03932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36BF170-33B5-5F41-B35E-8AE418A959B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06547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36BF170-33B5-5F41-B35E-8AE418A959B9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141859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36BF170-33B5-5F41-B35E-8AE418A959B9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966841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36BF170-33B5-5F41-B35E-8AE418A959B9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808367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36BF170-33B5-5F41-B35E-8AE418A959B9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28027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3CE83-74FE-CA43-B0A5-812A83DE21A7}" type="datetimeFigureOut">
              <a:rPr kumimoji="1" lang="ja-JP" altLang="en-US" smtClean="0"/>
              <a:t>2022/1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4635E-3D79-EF44-B02A-011360BD30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03759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3CE83-74FE-CA43-B0A5-812A83DE21A7}" type="datetimeFigureOut">
              <a:rPr kumimoji="1" lang="ja-JP" altLang="en-US" smtClean="0"/>
              <a:t>2022/1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4635E-3D79-EF44-B02A-011360BD30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0795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3CE83-74FE-CA43-B0A5-812A83DE21A7}" type="datetimeFigureOut">
              <a:rPr kumimoji="1" lang="ja-JP" altLang="en-US" smtClean="0"/>
              <a:t>2022/1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4635E-3D79-EF44-B02A-011360BD30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90539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3CE83-74FE-CA43-B0A5-812A83DE21A7}" type="datetimeFigureOut">
              <a:rPr kumimoji="1" lang="ja-JP" altLang="en-US" smtClean="0"/>
              <a:t>2022/1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4635E-3D79-EF44-B02A-011360BD30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240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3CE83-74FE-CA43-B0A5-812A83DE21A7}" type="datetimeFigureOut">
              <a:rPr kumimoji="1" lang="ja-JP" altLang="en-US" smtClean="0"/>
              <a:t>2022/1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4635E-3D79-EF44-B02A-011360BD30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8036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3CE83-74FE-CA43-B0A5-812A83DE21A7}" type="datetimeFigureOut">
              <a:rPr kumimoji="1" lang="ja-JP" altLang="en-US" smtClean="0"/>
              <a:t>2022/11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4635E-3D79-EF44-B02A-011360BD30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22697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3CE83-74FE-CA43-B0A5-812A83DE21A7}" type="datetimeFigureOut">
              <a:rPr kumimoji="1" lang="ja-JP" altLang="en-US" smtClean="0"/>
              <a:t>2022/11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4635E-3D79-EF44-B02A-011360BD30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82482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3CE83-74FE-CA43-B0A5-812A83DE21A7}" type="datetimeFigureOut">
              <a:rPr kumimoji="1" lang="ja-JP" altLang="en-US" smtClean="0"/>
              <a:t>2022/11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4635E-3D79-EF44-B02A-011360BD30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15968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3CE83-74FE-CA43-B0A5-812A83DE21A7}" type="datetimeFigureOut">
              <a:rPr kumimoji="1" lang="ja-JP" altLang="en-US" smtClean="0"/>
              <a:t>2022/11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4635E-3D79-EF44-B02A-011360BD30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11986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3CE83-74FE-CA43-B0A5-812A83DE21A7}" type="datetimeFigureOut">
              <a:rPr kumimoji="1" lang="ja-JP" altLang="en-US" smtClean="0"/>
              <a:t>2022/11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4635E-3D79-EF44-B02A-011360BD30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7506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E3CE83-74FE-CA43-B0A5-812A83DE21A7}" type="datetimeFigureOut">
              <a:rPr kumimoji="1" lang="ja-JP" altLang="en-US" smtClean="0"/>
              <a:t>2022/11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4635E-3D79-EF44-B02A-011360BD30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46362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E3CE83-74FE-CA43-B0A5-812A83DE21A7}" type="datetimeFigureOut">
              <a:rPr kumimoji="1" lang="ja-JP" altLang="en-US" smtClean="0"/>
              <a:t>2022/1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84635E-3D79-EF44-B02A-011360BD30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7422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4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2879C46-6385-5D3D-8B5F-39E52C4FA3D1}"/>
              </a:ext>
            </a:extLst>
          </p:cNvPr>
          <p:cNvSpPr txBox="1"/>
          <p:nvPr/>
        </p:nvSpPr>
        <p:spPr>
          <a:xfrm>
            <a:off x="28576" y="97787"/>
            <a:ext cx="2658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游ゴシック" panose="020B0400000000000000" pitchFamily="50" charset="-128"/>
              </a:rPr>
              <a:t>Supplementary T</a:t>
            </a:r>
            <a:r>
              <a:rPr kumimoji="1" lang="en-US" altLang="ja-JP" dirty="0">
                <a:solidFill>
                  <a:prstClr val="black"/>
                </a:solidFill>
                <a:latin typeface="Palatino Linotype" panose="02040502050505030304" pitchFamily="18" charset="0"/>
                <a:ea typeface="游ゴシック" panose="020B0400000000000000" pitchFamily="50" charset="-128"/>
              </a:rPr>
              <a:t>able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游ゴシック" panose="020B0400000000000000" pitchFamily="50" charset="-128"/>
              </a:rPr>
              <a:t> S1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66B932E-3B8C-66EB-3C8B-BF1D93F93D69}"/>
              </a:ext>
            </a:extLst>
          </p:cNvPr>
          <p:cNvSpPr txBox="1"/>
          <p:nvPr/>
        </p:nvSpPr>
        <p:spPr>
          <a:xfrm>
            <a:off x="673200" y="2425883"/>
            <a:ext cx="55116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1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able</a:t>
            </a:r>
            <a:r>
              <a:rPr lang="en-US" altLang="ja-JP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1.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mounts of </a:t>
            </a:r>
            <a:r>
              <a:rPr lang="en-US" altLang="ja-JP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iglyceride (TG) and total-cholesterol (T-Chol) per </a:t>
            </a:r>
            <a:r>
              <a:rPr lang="en-US" altLang="ja-JP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icrogram of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lipoproteins. LDL or HDL (0.2 mg/mL) was incubated with 0.5 mM CuSO</a:t>
            </a:r>
            <a:r>
              <a:rPr lang="en-US" altLang="ja-JP" sz="11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4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at 37 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  <a:sym typeface="Symbol" pitchFamily="2" charset="2"/>
              </a:rPr>
              <a:t>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 for 3 h, to prepare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xLDL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or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xHDL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respectively. </a:t>
            </a:r>
            <a:r>
              <a:rPr lang="en-US" altLang="ja-JP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e amounts of the TG and T-Chol in each lipoprotein </a:t>
            </a:r>
            <a:r>
              <a:rPr lang="en-US" altLang="ja-JP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ere measured by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enzymatic assay kits (Triglyceride E-test kit Wako and Cholesterol E-test kit Wako). LDL, low-density lipoprotein; HDL, high-density lipoprotein;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xLDL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oxidized LDL;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xHDL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oxidized HDL.</a:t>
            </a: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465135E1-A880-8791-770A-B70558B462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22595" y="815904"/>
            <a:ext cx="3812810" cy="11079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17607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2879C46-6385-5D3D-8B5F-39E52C4FA3D1}"/>
              </a:ext>
            </a:extLst>
          </p:cNvPr>
          <p:cNvSpPr txBox="1"/>
          <p:nvPr/>
        </p:nvSpPr>
        <p:spPr>
          <a:xfrm>
            <a:off x="28576" y="97787"/>
            <a:ext cx="27799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游ゴシック" panose="020B0400000000000000" pitchFamily="50" charset="-128"/>
              </a:rPr>
              <a:t>Supplementary Figure S</a:t>
            </a:r>
            <a:r>
              <a:rPr kumimoji="1" lang="en-US" altLang="ja-JP" dirty="0">
                <a:solidFill>
                  <a:prstClr val="black"/>
                </a:solidFill>
                <a:latin typeface="Palatino Linotype" panose="02040502050505030304" pitchFamily="18" charset="0"/>
                <a:ea typeface="游ゴシック" panose="020B0400000000000000" pitchFamily="50" charset="-128"/>
              </a:rPr>
              <a:t>1</a:t>
            </a:r>
            <a:endParaRPr kumimoji="1" lang="en-US" altLang="ja-JP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Palatino Linotype" panose="02040502050505030304" pitchFamily="18" charset="0"/>
              <a:ea typeface="游ゴシック" panose="020B0400000000000000" pitchFamily="50" charset="-128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66B932E-3B8C-66EB-3C8B-BF1D93F93D69}"/>
              </a:ext>
            </a:extLst>
          </p:cNvPr>
          <p:cNvSpPr txBox="1"/>
          <p:nvPr/>
        </p:nvSpPr>
        <p:spPr>
          <a:xfrm>
            <a:off x="673200" y="4373216"/>
            <a:ext cx="5511600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</a:t>
            </a:r>
            <a:r>
              <a:rPr lang="en-US" altLang="ja-JP" sz="11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ja-JP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Effect of pre-incubation time on the HDL’s ability to suppress NET formation. HL-60 cells were differentiated into neutrophil-like cells using 2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ll-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rans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retinoic acid.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</a:t>
            </a:r>
            <a:r>
              <a:rPr lang="en-US" altLang="ja-JP" sz="11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xLDL</a:t>
            </a:r>
            <a:r>
              <a:rPr lang="en-US" altLang="ja-JP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0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g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/mL</a:t>
            </a:r>
            <a:r>
              <a:rPr lang="en-US" altLang="ja-JP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was pre-incubated with </a:t>
            </a:r>
            <a:r>
              <a:rPr lang="en-US" altLang="ja-JP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L </a:t>
            </a:r>
            <a:r>
              <a:rPr lang="en-US" altLang="ja-JP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0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g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/mL</a:t>
            </a:r>
            <a:r>
              <a:rPr lang="en-US" altLang="ja-JP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t 37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  <a:sym typeface="Symbol" pitchFamily="2" charset="2"/>
              </a:rPr>
              <a:t> 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 for 1 or 4 h.</a:t>
            </a:r>
            <a:r>
              <a:rPr lang="en-US" altLang="ja-JP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cells were treated with 0 or 20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M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PMA for 30 min, then the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xLDL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ja-JP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ith or without HDL 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as added and incubated for 2 h. The DNA released into the medium after </a:t>
            </a:r>
            <a:r>
              <a:rPr lang="en-US" altLang="ja-JP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icrococcal nucle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se treatment was quantified using 1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YTOX</a:t>
            </a:r>
            <a:r>
              <a:rPr lang="en-US" altLang="ja-JP" sz="11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®︎ 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reen. The data represents mean </a:t>
            </a:r>
            <a:r>
              <a:rPr lang="zh-CN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± 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D. Asterisks indicate statistical significance (*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5), while sharps indicate statistical significance against the corresponding conditions without PMA (#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5). PMA, phorbol 12-myristate 13-acetate;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xLDL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oxidized low-density lipoprotein; HDL, high-density lipoprotein.</a:t>
            </a:r>
          </a:p>
        </p:txBody>
      </p:sp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FF93C52A-BF9B-3508-01B0-5EFF16F971C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6426440"/>
              </p:ext>
            </p:extLst>
          </p:nvPr>
        </p:nvGraphicFramePr>
        <p:xfrm>
          <a:off x="1568153" y="807188"/>
          <a:ext cx="3221999" cy="23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663F5651-0D73-54DA-6A2F-E955433A0FDC}"/>
              </a:ext>
            </a:extLst>
          </p:cNvPr>
          <p:cNvCxnSpPr>
            <a:cxnSpLocks/>
          </p:cNvCxnSpPr>
          <p:nvPr/>
        </p:nvCxnSpPr>
        <p:spPr>
          <a:xfrm>
            <a:off x="1906807" y="3023367"/>
            <a:ext cx="271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203">
            <a:extLst>
              <a:ext uri="{FF2B5EF4-FFF2-40B4-BE49-F238E27FC236}">
                <a16:creationId xmlns:a16="http://schemas.microsoft.com/office/drawing/2014/main" id="{10DB665F-F31A-4F6E-ECB6-B245B21ECE75}"/>
              </a:ext>
            </a:extLst>
          </p:cNvPr>
          <p:cNvSpPr txBox="1"/>
          <p:nvPr/>
        </p:nvSpPr>
        <p:spPr>
          <a:xfrm rot="16200000">
            <a:off x="884826" y="1745185"/>
            <a:ext cx="13548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luorescent intensity</a:t>
            </a:r>
            <a:endParaRPr lang="ja-JP" altLang="ja-JP" sz="10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graphicFrame>
        <p:nvGraphicFramePr>
          <p:cNvPr id="7" name="表 22">
            <a:extLst>
              <a:ext uri="{FF2B5EF4-FFF2-40B4-BE49-F238E27FC236}">
                <a16:creationId xmlns:a16="http://schemas.microsoft.com/office/drawing/2014/main" id="{9AB3FEDD-5BD2-27E8-F591-25E5D749501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1835376"/>
              </p:ext>
            </p:extLst>
          </p:nvPr>
        </p:nvGraphicFramePr>
        <p:xfrm>
          <a:off x="1266936" y="3057787"/>
          <a:ext cx="3892100" cy="97536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616779">
                  <a:extLst>
                    <a:ext uri="{9D8B030D-6E8A-4147-A177-3AD203B41FA5}">
                      <a16:colId xmlns:a16="http://schemas.microsoft.com/office/drawing/2014/main" val="1209081136"/>
                    </a:ext>
                  </a:extLst>
                </a:gridCol>
                <a:gridCol w="363764">
                  <a:extLst>
                    <a:ext uri="{9D8B030D-6E8A-4147-A177-3AD203B41FA5}">
                      <a16:colId xmlns:a16="http://schemas.microsoft.com/office/drawing/2014/main" val="3088413247"/>
                    </a:ext>
                  </a:extLst>
                </a:gridCol>
                <a:gridCol w="357379">
                  <a:extLst>
                    <a:ext uri="{9D8B030D-6E8A-4147-A177-3AD203B41FA5}">
                      <a16:colId xmlns:a16="http://schemas.microsoft.com/office/drawing/2014/main" val="1057090668"/>
                    </a:ext>
                  </a:extLst>
                </a:gridCol>
                <a:gridCol w="334447">
                  <a:extLst>
                    <a:ext uri="{9D8B030D-6E8A-4147-A177-3AD203B41FA5}">
                      <a16:colId xmlns:a16="http://schemas.microsoft.com/office/drawing/2014/main" val="777563651"/>
                    </a:ext>
                  </a:extLst>
                </a:gridCol>
                <a:gridCol w="334577">
                  <a:extLst>
                    <a:ext uri="{9D8B030D-6E8A-4147-A177-3AD203B41FA5}">
                      <a16:colId xmlns:a16="http://schemas.microsoft.com/office/drawing/2014/main" val="993493571"/>
                    </a:ext>
                  </a:extLst>
                </a:gridCol>
                <a:gridCol w="360726">
                  <a:extLst>
                    <a:ext uri="{9D8B030D-6E8A-4147-A177-3AD203B41FA5}">
                      <a16:colId xmlns:a16="http://schemas.microsoft.com/office/drawing/2014/main" val="2529506105"/>
                    </a:ext>
                  </a:extLst>
                </a:gridCol>
                <a:gridCol w="327171">
                  <a:extLst>
                    <a:ext uri="{9D8B030D-6E8A-4147-A177-3AD203B41FA5}">
                      <a16:colId xmlns:a16="http://schemas.microsoft.com/office/drawing/2014/main" val="3270355049"/>
                    </a:ext>
                  </a:extLst>
                </a:gridCol>
                <a:gridCol w="352338">
                  <a:extLst>
                    <a:ext uri="{9D8B030D-6E8A-4147-A177-3AD203B41FA5}">
                      <a16:colId xmlns:a16="http://schemas.microsoft.com/office/drawing/2014/main" val="3900257484"/>
                    </a:ext>
                  </a:extLst>
                </a:gridCol>
                <a:gridCol w="327170">
                  <a:extLst>
                    <a:ext uri="{9D8B030D-6E8A-4147-A177-3AD203B41FA5}">
                      <a16:colId xmlns:a16="http://schemas.microsoft.com/office/drawing/2014/main" val="3928527817"/>
                    </a:ext>
                  </a:extLst>
                </a:gridCol>
                <a:gridCol w="517749">
                  <a:extLst>
                    <a:ext uri="{9D8B030D-6E8A-4147-A177-3AD203B41FA5}">
                      <a16:colId xmlns:a16="http://schemas.microsoft.com/office/drawing/2014/main" val="378971868"/>
                    </a:ext>
                  </a:extLst>
                </a:gridCol>
              </a:tblGrid>
              <a:tr h="176019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dirty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PMA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800" b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ー</a:t>
                      </a: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800" b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ー</a:t>
                      </a: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800" b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ー</a:t>
                      </a: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800" b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ー</a:t>
                      </a: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kumimoji="1" lang="en-US" altLang="ja-JP" sz="8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4947207"/>
                  </a:ext>
                </a:extLst>
              </a:tr>
              <a:tr h="176019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oxLDL</a:t>
                      </a: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800" b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ー</a:t>
                      </a: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kumimoji="1" lang="en-US" altLang="ja-JP" sz="8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800" b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ー</a:t>
                      </a: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kumimoji="1" lang="en-US" altLang="ja-JP" sz="8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kumimoji="1" lang="en-US" altLang="ja-JP" sz="8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μg</a:t>
                      </a:r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l]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422009"/>
                  </a:ext>
                </a:extLst>
              </a:tr>
              <a:tr h="176019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dirty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HDL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800" b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ー</a:t>
                      </a: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800" b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ー</a:t>
                      </a: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800" b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ー</a:t>
                      </a: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800" b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ー</a:t>
                      </a: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dirty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kumimoji="1" lang="en-US" altLang="ja-JP" sz="8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μg</a:t>
                      </a:r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l]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56426616"/>
                  </a:ext>
                </a:extLst>
              </a:tr>
              <a:tr h="176019">
                <a:tc grid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dirty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Pre-incubation time at 37</a:t>
                      </a:r>
                      <a:r>
                        <a:rPr kumimoji="1" lang="ja-JP" altLang="en-US" sz="800" b="0"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℃</a:t>
                      </a:r>
                      <a:endParaRPr kumimoji="1" lang="en-US" altLang="ja-JP" sz="800" b="0" dirty="0"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h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h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dirty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1h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h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6147420"/>
                  </a:ext>
                </a:extLst>
              </a:tr>
            </a:tbl>
          </a:graphicData>
        </a:graphic>
      </p:graphicFrame>
      <p:sp>
        <p:nvSpPr>
          <p:cNvPr id="8" name="左大かっこ 7">
            <a:extLst>
              <a:ext uri="{FF2B5EF4-FFF2-40B4-BE49-F238E27FC236}">
                <a16:creationId xmlns:a16="http://schemas.microsoft.com/office/drawing/2014/main" id="{57775171-3343-A318-E23B-2A6DBA3890F0}"/>
              </a:ext>
            </a:extLst>
          </p:cNvPr>
          <p:cNvSpPr/>
          <p:nvPr/>
        </p:nvSpPr>
        <p:spPr>
          <a:xfrm rot="5400000">
            <a:off x="2219198" y="2065636"/>
            <a:ext cx="46802" cy="288000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F7395F2-4248-74D5-61FD-15D45C21A591}"/>
              </a:ext>
            </a:extLst>
          </p:cNvPr>
          <p:cNvSpPr txBox="1"/>
          <p:nvPr/>
        </p:nvSpPr>
        <p:spPr>
          <a:xfrm>
            <a:off x="2150757" y="2038044"/>
            <a:ext cx="183685" cy="2308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900" dirty="0"/>
              <a:t>*</a:t>
            </a:r>
            <a:endParaRPr kumimoji="1" lang="ja-JP" altLang="en-US" sz="900"/>
          </a:p>
        </p:txBody>
      </p:sp>
      <p:sp>
        <p:nvSpPr>
          <p:cNvPr id="10" name="左大かっこ 9">
            <a:extLst>
              <a:ext uri="{FF2B5EF4-FFF2-40B4-BE49-F238E27FC236}">
                <a16:creationId xmlns:a16="http://schemas.microsoft.com/office/drawing/2014/main" id="{C2788883-C8A2-7D44-1055-8EBF44E2C474}"/>
              </a:ext>
            </a:extLst>
          </p:cNvPr>
          <p:cNvSpPr/>
          <p:nvPr/>
        </p:nvSpPr>
        <p:spPr>
          <a:xfrm rot="5400000">
            <a:off x="3597371" y="1440990"/>
            <a:ext cx="46802" cy="288000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1E0663B-37B9-D8BC-1D58-DCA2550B8CCC}"/>
              </a:ext>
            </a:extLst>
          </p:cNvPr>
          <p:cNvSpPr txBox="1"/>
          <p:nvPr/>
        </p:nvSpPr>
        <p:spPr>
          <a:xfrm>
            <a:off x="3528930" y="1413398"/>
            <a:ext cx="183685" cy="2308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900" dirty="0"/>
              <a:t>*</a:t>
            </a:r>
            <a:endParaRPr kumimoji="1" lang="ja-JP" altLang="en-US" sz="900"/>
          </a:p>
        </p:txBody>
      </p:sp>
      <p:sp>
        <p:nvSpPr>
          <p:cNvPr id="12" name="左大かっこ 11">
            <a:extLst>
              <a:ext uri="{FF2B5EF4-FFF2-40B4-BE49-F238E27FC236}">
                <a16:creationId xmlns:a16="http://schemas.microsoft.com/office/drawing/2014/main" id="{86DDFC3E-577C-3968-B9F1-E0ACB0923810}"/>
              </a:ext>
            </a:extLst>
          </p:cNvPr>
          <p:cNvSpPr/>
          <p:nvPr/>
        </p:nvSpPr>
        <p:spPr>
          <a:xfrm rot="5400000">
            <a:off x="4122090" y="1255159"/>
            <a:ext cx="46802" cy="648000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F3EB03F-2AA1-5531-8F51-923E26E158F7}"/>
              </a:ext>
            </a:extLst>
          </p:cNvPr>
          <p:cNvSpPr txBox="1"/>
          <p:nvPr/>
        </p:nvSpPr>
        <p:spPr>
          <a:xfrm>
            <a:off x="4053649" y="1407567"/>
            <a:ext cx="183685" cy="2308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900" dirty="0"/>
              <a:t>*</a:t>
            </a:r>
            <a:endParaRPr kumimoji="1" lang="ja-JP" altLang="en-US" sz="90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003E29A-D0AB-514D-2E6F-24833CC0C3FC}"/>
              </a:ext>
            </a:extLst>
          </p:cNvPr>
          <p:cNvSpPr txBox="1"/>
          <p:nvPr/>
        </p:nvSpPr>
        <p:spPr>
          <a:xfrm>
            <a:off x="3799275" y="1831486"/>
            <a:ext cx="183685" cy="2308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900" dirty="0"/>
              <a:t>#</a:t>
            </a:r>
            <a:endParaRPr kumimoji="1" lang="ja-JP" altLang="en-US" sz="90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073E212-73FB-3C8E-128A-932485317834}"/>
              </a:ext>
            </a:extLst>
          </p:cNvPr>
          <p:cNvSpPr txBox="1"/>
          <p:nvPr/>
        </p:nvSpPr>
        <p:spPr>
          <a:xfrm>
            <a:off x="4148022" y="2069691"/>
            <a:ext cx="183685" cy="2308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900" dirty="0"/>
              <a:t>#</a:t>
            </a:r>
            <a:endParaRPr kumimoji="1" lang="ja-JP" altLang="en-US" sz="900"/>
          </a:p>
        </p:txBody>
      </p:sp>
    </p:spTree>
    <p:extLst>
      <p:ext uri="{BB962C8B-B14F-4D97-AF65-F5344CB8AC3E}">
        <p14:creationId xmlns:p14="http://schemas.microsoft.com/office/powerpoint/2010/main" val="28195704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2879C46-6385-5D3D-8B5F-39E52C4FA3D1}"/>
              </a:ext>
            </a:extLst>
          </p:cNvPr>
          <p:cNvSpPr txBox="1"/>
          <p:nvPr/>
        </p:nvSpPr>
        <p:spPr>
          <a:xfrm>
            <a:off x="28576" y="97787"/>
            <a:ext cx="27799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游ゴシック" panose="020B0400000000000000" pitchFamily="50" charset="-128"/>
              </a:rPr>
              <a:t>Supplementary Figure S2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altLang="ja-JP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Palatino Linotype" panose="02040502050505030304" pitchFamily="18" charset="0"/>
              <a:ea typeface="游ゴシック" panose="020B0400000000000000" pitchFamily="50" charset="-128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66B932E-3B8C-66EB-3C8B-BF1D93F93D69}"/>
              </a:ext>
            </a:extLst>
          </p:cNvPr>
          <p:cNvSpPr txBox="1"/>
          <p:nvPr/>
        </p:nvSpPr>
        <p:spPr>
          <a:xfrm>
            <a:off x="673200" y="4085352"/>
            <a:ext cx="5511600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ja-JP" sz="11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2</a:t>
            </a:r>
            <a:r>
              <a:rPr lang="en-US" altLang="ja-JP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Effect of HDL on the DNA release from neutrophils </a:t>
            </a:r>
            <a:r>
              <a:rPr lang="en-US" altLang="ja-JP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n the absence of </a:t>
            </a:r>
            <a:r>
              <a:rPr lang="en-US" altLang="ja-JP" sz="11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xLDL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HL-60 cells were differentiated into neutrophil-like cells using 2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ll-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rans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retinoic acid. The </a:t>
            </a:r>
            <a:r>
              <a:rPr lang="en-US" altLang="ja-JP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lls were treated with 0 or 20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M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PMA </a:t>
            </a:r>
            <a:r>
              <a:rPr lang="en-US" altLang="ja-JP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llowed by 20 or 40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g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/mL of HDL for 2 h. The DNA released into the medium after </a:t>
            </a:r>
            <a:r>
              <a:rPr lang="en-US" altLang="ja-JP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icrococcal nucle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se treatment was quantified using 1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YTOX</a:t>
            </a:r>
            <a:r>
              <a:rPr lang="en-US" altLang="ja-JP" sz="11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®︎ 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reen. The data represents mean </a:t>
            </a:r>
            <a:r>
              <a:rPr lang="zh-CN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± 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D. Asterisks indicate statistical significance (*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5), while sharps indicate statistical significance against the corresponding conditions without PMA (#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5). PMA, phorbol 12-myristate 13-acetate; HDL, high-density lipoprotein</a:t>
            </a:r>
            <a:r>
              <a:rPr lang="en-US" altLang="ja-JP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endParaRPr lang="en-US" altLang="ja-JP" sz="1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D133CC82-AAD1-1E90-02ED-98935B4B25E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6218701"/>
              </p:ext>
            </p:extLst>
          </p:nvPr>
        </p:nvGraphicFramePr>
        <p:xfrm>
          <a:off x="1609632" y="926919"/>
          <a:ext cx="3221999" cy="23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F144AB87-C571-E884-CC64-3EC80F0A34FA}"/>
              </a:ext>
            </a:extLst>
          </p:cNvPr>
          <p:cNvCxnSpPr>
            <a:cxnSpLocks/>
          </p:cNvCxnSpPr>
          <p:nvPr/>
        </p:nvCxnSpPr>
        <p:spPr>
          <a:xfrm>
            <a:off x="1948793" y="3149641"/>
            <a:ext cx="271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203">
            <a:extLst>
              <a:ext uri="{FF2B5EF4-FFF2-40B4-BE49-F238E27FC236}">
                <a16:creationId xmlns:a16="http://schemas.microsoft.com/office/drawing/2014/main" id="{AE9E6C05-55E7-0276-B769-424D24DDD6C0}"/>
              </a:ext>
            </a:extLst>
          </p:cNvPr>
          <p:cNvSpPr txBox="1"/>
          <p:nvPr/>
        </p:nvSpPr>
        <p:spPr>
          <a:xfrm rot="16200000">
            <a:off x="899435" y="1910471"/>
            <a:ext cx="13548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luorescent intensity</a:t>
            </a:r>
            <a:endParaRPr lang="ja-JP" altLang="ja-JP" sz="10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graphicFrame>
        <p:nvGraphicFramePr>
          <p:cNvPr id="19" name="表 22">
            <a:extLst>
              <a:ext uri="{FF2B5EF4-FFF2-40B4-BE49-F238E27FC236}">
                <a16:creationId xmlns:a16="http://schemas.microsoft.com/office/drawing/2014/main" id="{5FFD8DA1-D4EE-F439-88C5-D1F6A7BCBF2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5420770"/>
              </p:ext>
            </p:extLst>
          </p:nvPr>
        </p:nvGraphicFramePr>
        <p:xfrm>
          <a:off x="1502176" y="3226472"/>
          <a:ext cx="3725874" cy="42672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25648">
                  <a:extLst>
                    <a:ext uri="{9D8B030D-6E8A-4147-A177-3AD203B41FA5}">
                      <a16:colId xmlns:a16="http://schemas.microsoft.com/office/drawing/2014/main" val="1209081136"/>
                    </a:ext>
                  </a:extLst>
                </a:gridCol>
                <a:gridCol w="331191">
                  <a:extLst>
                    <a:ext uri="{9D8B030D-6E8A-4147-A177-3AD203B41FA5}">
                      <a16:colId xmlns:a16="http://schemas.microsoft.com/office/drawing/2014/main" val="3088413247"/>
                    </a:ext>
                  </a:extLst>
                </a:gridCol>
                <a:gridCol w="553674">
                  <a:extLst>
                    <a:ext uri="{9D8B030D-6E8A-4147-A177-3AD203B41FA5}">
                      <a16:colId xmlns:a16="http://schemas.microsoft.com/office/drawing/2014/main" val="777563651"/>
                    </a:ext>
                  </a:extLst>
                </a:gridCol>
                <a:gridCol w="352337">
                  <a:extLst>
                    <a:ext uri="{9D8B030D-6E8A-4147-A177-3AD203B41FA5}">
                      <a16:colId xmlns:a16="http://schemas.microsoft.com/office/drawing/2014/main" val="993493571"/>
                    </a:ext>
                  </a:extLst>
                </a:gridCol>
                <a:gridCol w="587230">
                  <a:extLst>
                    <a:ext uri="{9D8B030D-6E8A-4147-A177-3AD203B41FA5}">
                      <a16:colId xmlns:a16="http://schemas.microsoft.com/office/drawing/2014/main" val="2529506105"/>
                    </a:ext>
                  </a:extLst>
                </a:gridCol>
                <a:gridCol w="360726">
                  <a:extLst>
                    <a:ext uri="{9D8B030D-6E8A-4147-A177-3AD203B41FA5}">
                      <a16:colId xmlns:a16="http://schemas.microsoft.com/office/drawing/2014/main" val="3900257484"/>
                    </a:ext>
                  </a:extLst>
                </a:gridCol>
                <a:gridCol w="490344">
                  <a:extLst>
                    <a:ext uri="{9D8B030D-6E8A-4147-A177-3AD203B41FA5}">
                      <a16:colId xmlns:a16="http://schemas.microsoft.com/office/drawing/2014/main" val="3928527817"/>
                    </a:ext>
                  </a:extLst>
                </a:gridCol>
                <a:gridCol w="524724">
                  <a:extLst>
                    <a:ext uri="{9D8B030D-6E8A-4147-A177-3AD203B41FA5}">
                      <a16:colId xmlns:a16="http://schemas.microsoft.com/office/drawing/2014/main" val="1919364003"/>
                    </a:ext>
                  </a:extLst>
                </a:gridCol>
              </a:tblGrid>
              <a:tr h="176019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dirty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PMA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800" b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ー</a:t>
                      </a: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800" b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ー</a:t>
                      </a: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800" b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ー</a:t>
                      </a: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kumimoji="1" lang="en-US" altLang="ja-JP" sz="8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4947207"/>
                  </a:ext>
                </a:extLst>
              </a:tr>
              <a:tr h="176019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dirty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HDL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800" b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ー</a:t>
                      </a: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800" b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ー</a:t>
                      </a:r>
                      <a:endParaRPr kumimoji="1" lang="en-US" altLang="ja-JP" sz="800" b="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dirty="0"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kumimoji="1" lang="en-US" altLang="ja-JP" sz="8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μg</a:t>
                      </a:r>
                      <a:r>
                        <a:rPr kumimoji="1" lang="en-US" altLang="ja-JP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l]</a:t>
                      </a:r>
                      <a:endParaRPr kumimoji="1" lang="ja-JP" altLang="en-US" sz="800" b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56426616"/>
                  </a:ext>
                </a:extLst>
              </a:tr>
            </a:tbl>
          </a:graphicData>
        </a:graphic>
      </p:graphicFrame>
      <p:sp>
        <p:nvSpPr>
          <p:cNvPr id="20" name="テキスト ボックス 8">
            <a:extLst>
              <a:ext uri="{FF2B5EF4-FFF2-40B4-BE49-F238E27FC236}">
                <a16:creationId xmlns:a16="http://schemas.microsoft.com/office/drawing/2014/main" id="{E644D63F-8588-528E-5B50-10BE7C1084B5}"/>
              </a:ext>
            </a:extLst>
          </p:cNvPr>
          <p:cNvSpPr txBox="1"/>
          <p:nvPr/>
        </p:nvSpPr>
        <p:spPr>
          <a:xfrm>
            <a:off x="3888963" y="1515160"/>
            <a:ext cx="246222" cy="2308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900" dirty="0"/>
              <a:t>*</a:t>
            </a:r>
            <a:endParaRPr kumimoji="1" lang="ja-JP" altLang="en-US" sz="900"/>
          </a:p>
        </p:txBody>
      </p:sp>
      <p:sp>
        <p:nvSpPr>
          <p:cNvPr id="21" name="左大かっこ 20">
            <a:extLst>
              <a:ext uri="{FF2B5EF4-FFF2-40B4-BE49-F238E27FC236}">
                <a16:creationId xmlns:a16="http://schemas.microsoft.com/office/drawing/2014/main" id="{874407D9-3133-D670-F026-ADD8FCF6C62B}"/>
              </a:ext>
            </a:extLst>
          </p:cNvPr>
          <p:cNvSpPr/>
          <p:nvPr/>
        </p:nvSpPr>
        <p:spPr>
          <a:xfrm rot="5400000">
            <a:off x="3988674" y="1280927"/>
            <a:ext cx="46800" cy="883329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72C139A-8BED-D6A8-27D7-A7F34A332E83}"/>
              </a:ext>
            </a:extLst>
          </p:cNvPr>
          <p:cNvSpPr txBox="1"/>
          <p:nvPr/>
        </p:nvSpPr>
        <p:spPr>
          <a:xfrm>
            <a:off x="3570409" y="1891889"/>
            <a:ext cx="183685" cy="2308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900" dirty="0"/>
              <a:t>#</a:t>
            </a:r>
            <a:endParaRPr kumimoji="1" lang="ja-JP" altLang="en-US" sz="90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C52505D-744E-4AD2-D73B-4B0DC359EB5C}"/>
              </a:ext>
            </a:extLst>
          </p:cNvPr>
          <p:cNvSpPr txBox="1"/>
          <p:nvPr/>
        </p:nvSpPr>
        <p:spPr>
          <a:xfrm>
            <a:off x="4044542" y="2052900"/>
            <a:ext cx="183685" cy="2308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900" dirty="0"/>
              <a:t>#</a:t>
            </a:r>
            <a:endParaRPr kumimoji="1" lang="ja-JP" altLang="en-US" sz="90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62F378C-23F5-3757-EB0E-9214DD1204CB}"/>
              </a:ext>
            </a:extLst>
          </p:cNvPr>
          <p:cNvSpPr txBox="1"/>
          <p:nvPr/>
        </p:nvSpPr>
        <p:spPr>
          <a:xfrm>
            <a:off x="4482601" y="2066950"/>
            <a:ext cx="183685" cy="2308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900" dirty="0"/>
              <a:t>#</a:t>
            </a:r>
            <a:endParaRPr kumimoji="1" lang="ja-JP" altLang="en-US" sz="900"/>
          </a:p>
        </p:txBody>
      </p:sp>
    </p:spTree>
    <p:extLst>
      <p:ext uri="{BB962C8B-B14F-4D97-AF65-F5344CB8AC3E}">
        <p14:creationId xmlns:p14="http://schemas.microsoft.com/office/powerpoint/2010/main" val="40985021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2879C46-6385-5D3D-8B5F-39E52C4FA3D1}"/>
              </a:ext>
            </a:extLst>
          </p:cNvPr>
          <p:cNvSpPr txBox="1"/>
          <p:nvPr/>
        </p:nvSpPr>
        <p:spPr>
          <a:xfrm>
            <a:off x="0" y="105739"/>
            <a:ext cx="27799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游ゴシック" panose="020B0400000000000000" pitchFamily="50" charset="-128"/>
              </a:rPr>
              <a:t>Supplementary Figure S3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76B5BCD-0900-4587-8D64-B9ECC1144F32}"/>
              </a:ext>
            </a:extLst>
          </p:cNvPr>
          <p:cNvSpPr txBox="1"/>
          <p:nvPr/>
        </p:nvSpPr>
        <p:spPr>
          <a:xfrm rot="16200000">
            <a:off x="477246" y="2024305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TBARS</a:t>
            </a:r>
            <a:endParaRPr kumimoji="1" lang="ja-JP" altLang="en-US" sz="12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421E22A-1AD1-20A7-5EF8-867ACA01C298}"/>
              </a:ext>
            </a:extLst>
          </p:cNvPr>
          <p:cNvSpPr txBox="1"/>
          <p:nvPr/>
        </p:nvSpPr>
        <p:spPr>
          <a:xfrm rot="16200000">
            <a:off x="3148315" y="2024306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TBARS</a:t>
            </a:r>
            <a:endParaRPr kumimoji="1" lang="ja-JP" altLang="en-US" sz="12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D9F1403-35AA-F387-578D-A7974B55618C}"/>
              </a:ext>
            </a:extLst>
          </p:cNvPr>
          <p:cNvSpPr txBox="1"/>
          <p:nvPr/>
        </p:nvSpPr>
        <p:spPr>
          <a:xfrm>
            <a:off x="1454108" y="3351660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DL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4F374E1-BFC7-714C-4C00-74A99F1FEA48}"/>
              </a:ext>
            </a:extLst>
          </p:cNvPr>
          <p:cNvSpPr txBox="1"/>
          <p:nvPr/>
        </p:nvSpPr>
        <p:spPr>
          <a:xfrm>
            <a:off x="2213090" y="3351660"/>
            <a:ext cx="8739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u-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oxLDL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45ED250-3129-FA22-569A-6F111CC1FF01}"/>
              </a:ext>
            </a:extLst>
          </p:cNvPr>
          <p:cNvSpPr txBox="1"/>
          <p:nvPr/>
        </p:nvSpPr>
        <p:spPr>
          <a:xfrm>
            <a:off x="4138290" y="3351660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DL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FB6516D-FC8A-CF02-DEB7-98FD570724F9}"/>
              </a:ext>
            </a:extLst>
          </p:cNvPr>
          <p:cNvSpPr txBox="1"/>
          <p:nvPr/>
        </p:nvSpPr>
        <p:spPr>
          <a:xfrm>
            <a:off x="4897272" y="3351660"/>
            <a:ext cx="8996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u-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oxHDL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FA943615-B4C5-3F4A-8507-EC7D6F01E38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269399"/>
              </p:ext>
            </p:extLst>
          </p:nvPr>
        </p:nvGraphicFramePr>
        <p:xfrm>
          <a:off x="926452" y="1067939"/>
          <a:ext cx="2263002" cy="23221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AA467C9A-17BB-CE4D-B014-5A5A0D4CF46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42217734"/>
              </p:ext>
            </p:extLst>
          </p:nvPr>
        </p:nvGraphicFramePr>
        <p:xfrm>
          <a:off x="3580187" y="1067938"/>
          <a:ext cx="2267575" cy="23221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13093B35-A983-8B39-4947-B35948AD24AA}"/>
              </a:ext>
            </a:extLst>
          </p:cNvPr>
          <p:cNvCxnSpPr/>
          <p:nvPr/>
        </p:nvCxnSpPr>
        <p:spPr>
          <a:xfrm>
            <a:off x="1249960" y="3246539"/>
            <a:ext cx="182869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5E8E73F5-9AB3-0D5E-72AD-7E1B4A025D47}"/>
              </a:ext>
            </a:extLst>
          </p:cNvPr>
          <p:cNvCxnSpPr/>
          <p:nvPr/>
        </p:nvCxnSpPr>
        <p:spPr>
          <a:xfrm>
            <a:off x="3903524" y="3245246"/>
            <a:ext cx="182869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66B932E-3B8C-66EB-3C8B-BF1D93F93D69}"/>
              </a:ext>
            </a:extLst>
          </p:cNvPr>
          <p:cNvSpPr txBox="1"/>
          <p:nvPr/>
        </p:nvSpPr>
        <p:spPr>
          <a:xfrm>
            <a:off x="673200" y="4136149"/>
            <a:ext cx="5511600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3.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TBARS from native or copper-oxidized lipoproteins. An aliquot of LDL or HDL (0.2 mg/mL) was incubated with 0.5 mM CuSO4, at 37 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  <a:sym typeface="Symbol" pitchFamily="2" charset="2"/>
              </a:rPr>
              <a:t>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 for 3 h, to prepare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xLDL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or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xHDL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respectively.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xLDL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/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xHDL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was then mixed with TBA reagent containing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iobarbituric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cid and heated at 100 ºC for 15 min, following which the absorbance of the supernatant at the wavelength of 540 nm was measured. A calibration curve was drawn for the TBA-reactive substances standard using 1,1,3,3-tetraethoxypropane. This experiment was carried out in triplicate. TBARS,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iobarbituric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cid reactive substances; LDL, low-density lipoprotein; HDL, high-density lipoprotein;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xLDL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oxidized LDL;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xHDL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oxidized HDL.</a:t>
            </a:r>
          </a:p>
        </p:txBody>
      </p:sp>
    </p:spTree>
    <p:extLst>
      <p:ext uri="{BB962C8B-B14F-4D97-AF65-F5344CB8AC3E}">
        <p14:creationId xmlns:p14="http://schemas.microsoft.com/office/powerpoint/2010/main" val="8722910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5D3FD58-4660-0403-3DC4-4818240B5701}"/>
              </a:ext>
            </a:extLst>
          </p:cNvPr>
          <p:cNvSpPr txBox="1"/>
          <p:nvPr/>
        </p:nvSpPr>
        <p:spPr>
          <a:xfrm>
            <a:off x="28576" y="97787"/>
            <a:ext cx="27799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游ゴシック" panose="020B0400000000000000" pitchFamily="50" charset="-128"/>
              </a:rPr>
              <a:t>Supplementary Figure S4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4587F27-F73A-1197-AF08-1A2A06EAA5DA}"/>
              </a:ext>
            </a:extLst>
          </p:cNvPr>
          <p:cNvSpPr txBox="1"/>
          <p:nvPr/>
        </p:nvSpPr>
        <p:spPr>
          <a:xfrm>
            <a:off x="2476702" y="717738"/>
            <a:ext cx="6799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OVPC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74833B7-FD05-A6C7-5756-A609EDB3732C}"/>
              </a:ext>
            </a:extLst>
          </p:cNvPr>
          <p:cNvSpPr txBox="1"/>
          <p:nvPr/>
        </p:nvSpPr>
        <p:spPr>
          <a:xfrm>
            <a:off x="4781976" y="717738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GPC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EEFA7E9-1B04-B298-6210-ED528AB37934}"/>
              </a:ext>
            </a:extLst>
          </p:cNvPr>
          <p:cNvSpPr txBox="1"/>
          <p:nvPr/>
        </p:nvSpPr>
        <p:spPr>
          <a:xfrm>
            <a:off x="327779" y="2298554"/>
            <a:ext cx="6415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AzPC</a:t>
            </a:r>
            <a:endParaRPr kumimoji="1" lang="en-US" altLang="ja-JP" sz="11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325" name="テキスト ボックス 324">
            <a:extLst>
              <a:ext uri="{FF2B5EF4-FFF2-40B4-BE49-F238E27FC236}">
                <a16:creationId xmlns:a16="http://schemas.microsoft.com/office/drawing/2014/main" id="{E9AAEB72-91F8-52B7-60E5-A3C393B4C76B}"/>
              </a:ext>
            </a:extLst>
          </p:cNvPr>
          <p:cNvSpPr txBox="1"/>
          <p:nvPr/>
        </p:nvSpPr>
        <p:spPr>
          <a:xfrm>
            <a:off x="2476702" y="2298554"/>
            <a:ext cx="5709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APC</a:t>
            </a:r>
          </a:p>
        </p:txBody>
      </p:sp>
      <p:sp>
        <p:nvSpPr>
          <p:cNvPr id="326" name="テキスト ボックス 325">
            <a:extLst>
              <a:ext uri="{FF2B5EF4-FFF2-40B4-BE49-F238E27FC236}">
                <a16:creationId xmlns:a16="http://schemas.microsoft.com/office/drawing/2014/main" id="{2166181A-1FEE-B0C7-43EB-FA0EBFDA9513}"/>
              </a:ext>
            </a:extLst>
          </p:cNvPr>
          <p:cNvSpPr txBox="1"/>
          <p:nvPr/>
        </p:nvSpPr>
        <p:spPr>
          <a:xfrm>
            <a:off x="4781976" y="2298554"/>
            <a:ext cx="5549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LPC</a:t>
            </a:r>
          </a:p>
        </p:txBody>
      </p:sp>
      <p:pic>
        <p:nvPicPr>
          <p:cNvPr id="109" name="図 108">
            <a:extLst>
              <a:ext uri="{FF2B5EF4-FFF2-40B4-BE49-F238E27FC236}">
                <a16:creationId xmlns:a16="http://schemas.microsoft.com/office/drawing/2014/main" id="{01B7FE20-B5EE-EC74-5D7D-F449211D2A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76702" y="1025474"/>
            <a:ext cx="1597292" cy="857974"/>
          </a:xfrm>
          <a:prstGeom prst="rect">
            <a:avLst/>
          </a:prstGeom>
        </p:spPr>
      </p:pic>
      <p:pic>
        <p:nvPicPr>
          <p:cNvPr id="555" name="図 554">
            <a:extLst>
              <a:ext uri="{FF2B5EF4-FFF2-40B4-BE49-F238E27FC236}">
                <a16:creationId xmlns:a16="http://schemas.microsoft.com/office/drawing/2014/main" id="{BCA14013-3821-2EB8-92ED-3B1DAEC3700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7779" y="2626138"/>
            <a:ext cx="1597292" cy="857974"/>
          </a:xfrm>
          <a:prstGeom prst="rect">
            <a:avLst/>
          </a:prstGeom>
        </p:spPr>
      </p:pic>
      <p:pic>
        <p:nvPicPr>
          <p:cNvPr id="636" name="図 635">
            <a:extLst>
              <a:ext uri="{FF2B5EF4-FFF2-40B4-BE49-F238E27FC236}">
                <a16:creationId xmlns:a16="http://schemas.microsoft.com/office/drawing/2014/main" id="{39E9A499-6E0D-A7EA-F76E-4A5D99113FC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76702" y="2626138"/>
            <a:ext cx="2071915" cy="857974"/>
          </a:xfrm>
          <a:prstGeom prst="rect">
            <a:avLst/>
          </a:prstGeom>
        </p:spPr>
      </p:pic>
      <p:pic>
        <p:nvPicPr>
          <p:cNvPr id="698" name="図 697">
            <a:extLst>
              <a:ext uri="{FF2B5EF4-FFF2-40B4-BE49-F238E27FC236}">
                <a16:creationId xmlns:a16="http://schemas.microsoft.com/office/drawing/2014/main" id="{CDDCFD8F-51C1-4556-5722-EA2BB24A9DE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81976" y="1033749"/>
            <a:ext cx="1606420" cy="848847"/>
          </a:xfrm>
          <a:prstGeom prst="rect">
            <a:avLst/>
          </a:prstGeom>
        </p:spPr>
      </p:pic>
      <p:pic>
        <p:nvPicPr>
          <p:cNvPr id="841" name="図 840">
            <a:extLst>
              <a:ext uri="{FF2B5EF4-FFF2-40B4-BE49-F238E27FC236}">
                <a16:creationId xmlns:a16="http://schemas.microsoft.com/office/drawing/2014/main" id="{DBCF2ACD-91C7-5108-2C26-D958F9EA6B7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81975" y="2626138"/>
            <a:ext cx="1907623" cy="857974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1B3F7A8-EA48-E128-13D1-C11AFD0BAAF5}"/>
              </a:ext>
            </a:extLst>
          </p:cNvPr>
          <p:cNvSpPr txBox="1"/>
          <p:nvPr/>
        </p:nvSpPr>
        <p:spPr>
          <a:xfrm>
            <a:off x="327779" y="717738"/>
            <a:ext cx="6799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LysoPC</a:t>
            </a:r>
            <a:endParaRPr kumimoji="1" lang="en-US" altLang="ja-JP" sz="11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pic>
        <p:nvPicPr>
          <p:cNvPr id="526" name="図 525">
            <a:extLst>
              <a:ext uri="{FF2B5EF4-FFF2-40B4-BE49-F238E27FC236}">
                <a16:creationId xmlns:a16="http://schemas.microsoft.com/office/drawing/2014/main" id="{66394A08-45BB-7B36-E188-7FF0C009FEA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7778" y="1036492"/>
            <a:ext cx="1617553" cy="845822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B52AE65-680B-125A-60B1-C4AAC07D64EB}"/>
              </a:ext>
            </a:extLst>
          </p:cNvPr>
          <p:cNvSpPr txBox="1"/>
          <p:nvPr/>
        </p:nvSpPr>
        <p:spPr>
          <a:xfrm>
            <a:off x="673665" y="4163063"/>
            <a:ext cx="5560880" cy="9258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ts val="1300"/>
              </a:lnSpc>
            </a:pPr>
            <a:r>
              <a:rPr lang="en-US" altLang="ja-JP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4. 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tructures of the different phosphatidylcholines tested in this study.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ysoPC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1-palmitoyl-lysophosphatidylcholine; POVPC, 1-palmitoyl-2-(5-oxovaleroyl)-phosphatidylcholine; PGPC, 1-palmitoyl-2-glutaroyl-phosphatidylcholine;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AzPC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1-palmitoyl-2-azelaoyl-phospatidylcholine; PAPC, 1-palmitoyl-2-arachidonoyl-phospha-</a:t>
            </a:r>
          </a:p>
          <a:p>
            <a:pPr algn="just">
              <a:lnSpc>
                <a:spcPts val="1300"/>
              </a:lnSpc>
            </a:pP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idylcholine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; PLPC, 1-palmitoyl-2-linoleoyl-phospatidylcholine.</a:t>
            </a:r>
            <a:endParaRPr lang="ja-JP" altLang="ja-JP" sz="1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8695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1C3711B4-78DB-60FC-39C7-72D5E756C92B}"/>
              </a:ext>
            </a:extLst>
          </p:cNvPr>
          <p:cNvSpPr txBox="1"/>
          <p:nvPr/>
        </p:nvSpPr>
        <p:spPr>
          <a:xfrm>
            <a:off x="0" y="560781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(a)</a:t>
            </a:r>
            <a:endParaRPr kumimoji="1" lang="ja-JP" altLang="en-US" sz="14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252A1143-E1E5-3689-3244-B32874E748DA}"/>
              </a:ext>
            </a:extLst>
          </p:cNvPr>
          <p:cNvSpPr txBox="1"/>
          <p:nvPr/>
        </p:nvSpPr>
        <p:spPr>
          <a:xfrm>
            <a:off x="3352566" y="560781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(b)</a:t>
            </a:r>
            <a:endParaRPr kumimoji="1" lang="ja-JP" altLang="en-US" sz="14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93B65C70-8957-2482-756C-6CC8B912E10B}"/>
              </a:ext>
            </a:extLst>
          </p:cNvPr>
          <p:cNvSpPr txBox="1"/>
          <p:nvPr/>
        </p:nvSpPr>
        <p:spPr>
          <a:xfrm rot="19297851">
            <a:off x="765338" y="2787137"/>
            <a:ext cx="2952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9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ー</a:t>
            </a:r>
            <a:endParaRPr kumimoji="1" lang="en-US" altLang="ja-JP" sz="9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FD62A645-A42D-9F3A-CF67-D0D71B8FD32A}"/>
              </a:ext>
            </a:extLst>
          </p:cNvPr>
          <p:cNvSpPr txBox="1"/>
          <p:nvPr/>
        </p:nvSpPr>
        <p:spPr>
          <a:xfrm rot="19297851">
            <a:off x="951579" y="2788360"/>
            <a:ext cx="4764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MS PGothic" panose="020B0600070205080204" pitchFamily="34" charset="-128"/>
                <a:ea typeface="MS PGothic" panose="020B0600070205080204" pitchFamily="34" charset="-128"/>
                <a:cs typeface="Times New Roman" panose="02020603050405020304" pitchFamily="18" charset="0"/>
              </a:rPr>
              <a:t>PAPC</a:t>
            </a: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892DD0CD-4EF3-FA97-4938-87BF143467FF}"/>
              </a:ext>
            </a:extLst>
          </p:cNvPr>
          <p:cNvSpPr txBox="1"/>
          <p:nvPr/>
        </p:nvSpPr>
        <p:spPr>
          <a:xfrm rot="19297851">
            <a:off x="1192244" y="2787137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OVPC</a:t>
            </a: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82F4AFC3-371D-31C4-163D-59559036EFB5}"/>
              </a:ext>
            </a:extLst>
          </p:cNvPr>
          <p:cNvSpPr txBox="1"/>
          <p:nvPr/>
        </p:nvSpPr>
        <p:spPr>
          <a:xfrm rot="19297851">
            <a:off x="1562973" y="2789668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GPC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790241A-3CF5-802B-0208-C8F867BFDFD6}"/>
              </a:ext>
            </a:extLst>
          </p:cNvPr>
          <p:cNvSpPr txBox="1"/>
          <p:nvPr/>
        </p:nvSpPr>
        <p:spPr>
          <a:xfrm rot="16200000">
            <a:off x="-348223" y="1594820"/>
            <a:ext cx="13548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luorescent intensity</a:t>
            </a:r>
            <a:endParaRPr lang="ja-JP" altLang="ja-JP" sz="10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2381CAF2-2E44-FA3B-617A-D3394533891E}"/>
              </a:ext>
            </a:extLst>
          </p:cNvPr>
          <p:cNvCxnSpPr>
            <a:cxnSpLocks/>
          </p:cNvCxnSpPr>
          <p:nvPr/>
        </p:nvCxnSpPr>
        <p:spPr>
          <a:xfrm>
            <a:off x="797977" y="3084044"/>
            <a:ext cx="1191009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BA0FEB53-7A32-5BC7-ED11-66300529EE6B}"/>
              </a:ext>
            </a:extLst>
          </p:cNvPr>
          <p:cNvSpPr txBox="1"/>
          <p:nvPr/>
        </p:nvSpPr>
        <p:spPr>
          <a:xfrm>
            <a:off x="1015677" y="3105530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MA 0 </a:t>
            </a:r>
            <a:r>
              <a:rPr kumimoji="1" lang="en-US" altLang="ja-JP" sz="900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nM</a:t>
            </a:r>
            <a:endParaRPr kumimoji="1" lang="ja-JP" altLang="en-US" sz="9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BF8E1A7-5DAD-9EFD-91A6-8D9E47E18735}"/>
              </a:ext>
            </a:extLst>
          </p:cNvPr>
          <p:cNvSpPr txBox="1"/>
          <p:nvPr/>
        </p:nvSpPr>
        <p:spPr>
          <a:xfrm rot="19297851">
            <a:off x="2003951" y="2779819"/>
            <a:ext cx="2952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900">
                <a:latin typeface="MS PGothic" panose="020B0600070205080204" pitchFamily="34" charset="-128"/>
                <a:ea typeface="MS PGothic" panose="020B0600070205080204" pitchFamily="34" charset="-128"/>
                <a:cs typeface="Times New Roman" panose="02020603050405020304" pitchFamily="18" charset="0"/>
              </a:rPr>
              <a:t>ー</a:t>
            </a:r>
            <a:endParaRPr kumimoji="1" lang="en-US" altLang="ja-JP" sz="900" dirty="0">
              <a:latin typeface="MS PGothic" panose="020B0600070205080204" pitchFamily="34" charset="-128"/>
              <a:ea typeface="MS PGothic" panose="020B060007020508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131A57E8-AF7F-15F9-872C-FBFDC64E152B}"/>
              </a:ext>
            </a:extLst>
          </p:cNvPr>
          <p:cNvSpPr txBox="1"/>
          <p:nvPr/>
        </p:nvSpPr>
        <p:spPr>
          <a:xfrm rot="19297851">
            <a:off x="2178971" y="2781042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APC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D12C980-DBA9-56FC-6D11-325DFC305855}"/>
              </a:ext>
            </a:extLst>
          </p:cNvPr>
          <p:cNvSpPr txBox="1"/>
          <p:nvPr/>
        </p:nvSpPr>
        <p:spPr>
          <a:xfrm rot="19297851">
            <a:off x="2430857" y="2779819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OVPC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2552D1F-A6A8-8D8A-80E4-ADEBB7D9F294}"/>
              </a:ext>
            </a:extLst>
          </p:cNvPr>
          <p:cNvSpPr txBox="1"/>
          <p:nvPr/>
        </p:nvSpPr>
        <p:spPr>
          <a:xfrm rot="19297851">
            <a:off x="2801586" y="2782350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GPC</a:t>
            </a:r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409B1EF5-6D84-F0A2-7634-C78A70E1800E}"/>
              </a:ext>
            </a:extLst>
          </p:cNvPr>
          <p:cNvCxnSpPr>
            <a:cxnSpLocks/>
          </p:cNvCxnSpPr>
          <p:nvPr/>
        </p:nvCxnSpPr>
        <p:spPr>
          <a:xfrm>
            <a:off x="2036590" y="3084044"/>
            <a:ext cx="1191009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A9E0FFDD-E456-4584-8985-A677B4607DAA}"/>
              </a:ext>
            </a:extLst>
          </p:cNvPr>
          <p:cNvSpPr txBox="1"/>
          <p:nvPr/>
        </p:nvSpPr>
        <p:spPr>
          <a:xfrm>
            <a:off x="2222230" y="3098212"/>
            <a:ext cx="7873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MA 50 </a:t>
            </a:r>
            <a:r>
              <a:rPr kumimoji="1" lang="en-US" altLang="ja-JP" sz="900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nM</a:t>
            </a:r>
            <a:endParaRPr kumimoji="1" lang="ja-JP" altLang="en-US" sz="9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graphicFrame>
        <p:nvGraphicFramePr>
          <p:cNvPr id="32" name="グラフ 31">
            <a:extLst>
              <a:ext uri="{FF2B5EF4-FFF2-40B4-BE49-F238E27FC236}">
                <a16:creationId xmlns:a16="http://schemas.microsoft.com/office/drawing/2014/main" id="{E8467AC0-C5EE-7045-2850-81F8515E1A5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74592692"/>
              </p:ext>
            </p:extLst>
          </p:nvPr>
        </p:nvGraphicFramePr>
        <p:xfrm>
          <a:off x="423360" y="774599"/>
          <a:ext cx="2984399" cy="207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DBA5D1C0-258F-5F3F-82E8-43A404D0A583}"/>
              </a:ext>
            </a:extLst>
          </p:cNvPr>
          <p:cNvCxnSpPr>
            <a:cxnSpLocks/>
          </p:cNvCxnSpPr>
          <p:nvPr/>
        </p:nvCxnSpPr>
        <p:spPr>
          <a:xfrm>
            <a:off x="767071" y="2705105"/>
            <a:ext cx="24947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3" name="グラフ 32">
            <a:extLst>
              <a:ext uri="{FF2B5EF4-FFF2-40B4-BE49-F238E27FC236}">
                <a16:creationId xmlns:a16="http://schemas.microsoft.com/office/drawing/2014/main" id="{FA0D8EBE-7EF0-0B01-FC9F-B49879870597}"/>
              </a:ext>
            </a:extLst>
          </p:cNvPr>
          <p:cNvGraphicFramePr>
            <a:graphicFrameLocks/>
          </p:cNvGraphicFramePr>
          <p:nvPr/>
        </p:nvGraphicFramePr>
        <p:xfrm>
          <a:off x="3762155" y="766053"/>
          <a:ext cx="2984399" cy="207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6D6A32E6-9048-A50A-65D5-87858C82B838}"/>
              </a:ext>
            </a:extLst>
          </p:cNvPr>
          <p:cNvCxnSpPr>
            <a:cxnSpLocks/>
          </p:cNvCxnSpPr>
          <p:nvPr/>
        </p:nvCxnSpPr>
        <p:spPr>
          <a:xfrm>
            <a:off x="4105203" y="2699182"/>
            <a:ext cx="24947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0CD28D5D-9C06-2B18-62A9-AE57832D547D}"/>
              </a:ext>
            </a:extLst>
          </p:cNvPr>
          <p:cNvSpPr txBox="1"/>
          <p:nvPr/>
        </p:nvSpPr>
        <p:spPr>
          <a:xfrm rot="19438790">
            <a:off x="4459236" y="2779819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LPC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DAB23DFC-386E-5D4B-36A7-46940765FEDB}"/>
              </a:ext>
            </a:extLst>
          </p:cNvPr>
          <p:cNvSpPr txBox="1"/>
          <p:nvPr/>
        </p:nvSpPr>
        <p:spPr>
          <a:xfrm rot="19438790">
            <a:off x="4870326" y="2752924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AzPC</a:t>
            </a:r>
            <a:endParaRPr kumimoji="1" lang="en-US" altLang="ja-JP" sz="9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2C09CBCF-2B93-7B3E-5E82-1173B31DE863}"/>
              </a:ext>
            </a:extLst>
          </p:cNvPr>
          <p:cNvSpPr txBox="1"/>
          <p:nvPr/>
        </p:nvSpPr>
        <p:spPr>
          <a:xfrm rot="19438790">
            <a:off x="4162024" y="2791511"/>
            <a:ext cx="2952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9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ー</a:t>
            </a:r>
            <a:endParaRPr kumimoji="1" lang="en-US" altLang="ja-JP" sz="9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73CDF207-3F59-01DF-E975-6BE79373FB12}"/>
              </a:ext>
            </a:extLst>
          </p:cNvPr>
          <p:cNvCxnSpPr>
            <a:cxnSpLocks/>
          </p:cNvCxnSpPr>
          <p:nvPr/>
        </p:nvCxnSpPr>
        <p:spPr>
          <a:xfrm>
            <a:off x="4167261" y="3084044"/>
            <a:ext cx="1191009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3C14DB91-D561-E526-6B3D-4D154E50BCA9}"/>
              </a:ext>
            </a:extLst>
          </p:cNvPr>
          <p:cNvSpPr txBox="1"/>
          <p:nvPr/>
        </p:nvSpPr>
        <p:spPr>
          <a:xfrm>
            <a:off x="4384961" y="3102474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MA 0 </a:t>
            </a:r>
            <a:r>
              <a:rPr kumimoji="1" lang="en-US" altLang="ja-JP" sz="900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nM</a:t>
            </a:r>
            <a:endParaRPr kumimoji="1" lang="ja-JP" altLang="en-US" sz="9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48525E46-6A61-2322-A599-8D9B0AD17257}"/>
              </a:ext>
            </a:extLst>
          </p:cNvPr>
          <p:cNvSpPr txBox="1"/>
          <p:nvPr/>
        </p:nvSpPr>
        <p:spPr>
          <a:xfrm rot="19438790">
            <a:off x="5668749" y="2779819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LPC</a:t>
            </a: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7DE05443-A1BF-FE65-1B4C-0184716F658C}"/>
              </a:ext>
            </a:extLst>
          </p:cNvPr>
          <p:cNvSpPr txBox="1"/>
          <p:nvPr/>
        </p:nvSpPr>
        <p:spPr>
          <a:xfrm rot="19438790">
            <a:off x="6079839" y="2752924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AzPC</a:t>
            </a:r>
            <a:endParaRPr kumimoji="1" lang="en-US" altLang="ja-JP" sz="9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A4DFA99C-1206-234B-B96F-1724B450A936}"/>
              </a:ext>
            </a:extLst>
          </p:cNvPr>
          <p:cNvSpPr txBox="1"/>
          <p:nvPr/>
        </p:nvSpPr>
        <p:spPr>
          <a:xfrm rot="19438790">
            <a:off x="5371537" y="2791511"/>
            <a:ext cx="2952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9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ー</a:t>
            </a:r>
            <a:endParaRPr kumimoji="1" lang="en-US" altLang="ja-JP" sz="9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709BB6A9-B96A-2C33-9EB9-769B545610D8}"/>
              </a:ext>
            </a:extLst>
          </p:cNvPr>
          <p:cNvCxnSpPr>
            <a:cxnSpLocks/>
          </p:cNvCxnSpPr>
          <p:nvPr/>
        </p:nvCxnSpPr>
        <p:spPr>
          <a:xfrm>
            <a:off x="5376774" y="3084044"/>
            <a:ext cx="1191009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6AFDFCB4-4409-5EBF-618A-888F186EAC94}"/>
              </a:ext>
            </a:extLst>
          </p:cNvPr>
          <p:cNvSpPr txBox="1"/>
          <p:nvPr/>
        </p:nvSpPr>
        <p:spPr>
          <a:xfrm>
            <a:off x="5562414" y="3102474"/>
            <a:ext cx="7873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MA 50 </a:t>
            </a:r>
            <a:r>
              <a:rPr kumimoji="1" lang="en-US" altLang="ja-JP" sz="900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nM</a:t>
            </a:r>
            <a:endParaRPr kumimoji="1" lang="ja-JP" altLang="en-US" sz="9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D78B6A89-622C-F72F-58EC-BA555D2A205E}"/>
              </a:ext>
            </a:extLst>
          </p:cNvPr>
          <p:cNvSpPr txBox="1"/>
          <p:nvPr/>
        </p:nvSpPr>
        <p:spPr>
          <a:xfrm rot="16200000">
            <a:off x="3029707" y="1594820"/>
            <a:ext cx="13548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luorescent intensity</a:t>
            </a:r>
            <a:endParaRPr lang="ja-JP" altLang="ja-JP" sz="10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67" name="テキスト ボックス 8">
            <a:extLst>
              <a:ext uri="{FF2B5EF4-FFF2-40B4-BE49-F238E27FC236}">
                <a16:creationId xmlns:a16="http://schemas.microsoft.com/office/drawing/2014/main" id="{9212DBBE-34B8-2A34-4E61-D7CFD0B66085}"/>
              </a:ext>
            </a:extLst>
          </p:cNvPr>
          <p:cNvSpPr txBox="1"/>
          <p:nvPr/>
        </p:nvSpPr>
        <p:spPr>
          <a:xfrm>
            <a:off x="5613739" y="1137530"/>
            <a:ext cx="251671" cy="2308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ja-JP" altLang="en-US" sz="900"/>
              <a:t>＊</a:t>
            </a:r>
          </a:p>
        </p:txBody>
      </p:sp>
      <p:sp>
        <p:nvSpPr>
          <p:cNvPr id="68" name="左大かっこ 67">
            <a:extLst>
              <a:ext uri="{FF2B5EF4-FFF2-40B4-BE49-F238E27FC236}">
                <a16:creationId xmlns:a16="http://schemas.microsoft.com/office/drawing/2014/main" id="{C43112D1-4285-A392-81ED-934532ACAACB}"/>
              </a:ext>
            </a:extLst>
          </p:cNvPr>
          <p:cNvSpPr/>
          <p:nvPr/>
        </p:nvSpPr>
        <p:spPr>
          <a:xfrm rot="5400000">
            <a:off x="5733563" y="1094248"/>
            <a:ext cx="36000" cy="432000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テキスト ボックス 8">
            <a:extLst>
              <a:ext uri="{FF2B5EF4-FFF2-40B4-BE49-F238E27FC236}">
                <a16:creationId xmlns:a16="http://schemas.microsoft.com/office/drawing/2014/main" id="{12D6E0B9-FFFD-B65D-E0BD-2015846F8E5B}"/>
              </a:ext>
            </a:extLst>
          </p:cNvPr>
          <p:cNvSpPr txBox="1"/>
          <p:nvPr/>
        </p:nvSpPr>
        <p:spPr>
          <a:xfrm>
            <a:off x="5825757" y="997677"/>
            <a:ext cx="274434" cy="2308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ja-JP" altLang="en-US" sz="900"/>
              <a:t>＊</a:t>
            </a:r>
          </a:p>
        </p:txBody>
      </p:sp>
      <p:sp>
        <p:nvSpPr>
          <p:cNvPr id="70" name="左大かっこ 69">
            <a:extLst>
              <a:ext uri="{FF2B5EF4-FFF2-40B4-BE49-F238E27FC236}">
                <a16:creationId xmlns:a16="http://schemas.microsoft.com/office/drawing/2014/main" id="{075BDBED-8AAD-A912-5D9D-22DC5B739DA4}"/>
              </a:ext>
            </a:extLst>
          </p:cNvPr>
          <p:cNvSpPr/>
          <p:nvPr/>
        </p:nvSpPr>
        <p:spPr>
          <a:xfrm rot="5400000">
            <a:off x="5953942" y="752528"/>
            <a:ext cx="36000" cy="864000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テキスト ボックス 8">
            <a:extLst>
              <a:ext uri="{FF2B5EF4-FFF2-40B4-BE49-F238E27FC236}">
                <a16:creationId xmlns:a16="http://schemas.microsoft.com/office/drawing/2014/main" id="{DC9F61A6-6C50-EF48-E56F-29FFFC296610}"/>
              </a:ext>
            </a:extLst>
          </p:cNvPr>
          <p:cNvSpPr txBox="1"/>
          <p:nvPr/>
        </p:nvSpPr>
        <p:spPr>
          <a:xfrm>
            <a:off x="2482292" y="1084123"/>
            <a:ext cx="274434" cy="2308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ja-JP" altLang="en-US" sz="900"/>
              <a:t>＊</a:t>
            </a:r>
          </a:p>
        </p:txBody>
      </p:sp>
      <p:sp>
        <p:nvSpPr>
          <p:cNvPr id="74" name="左大かっこ 73">
            <a:extLst>
              <a:ext uri="{FF2B5EF4-FFF2-40B4-BE49-F238E27FC236}">
                <a16:creationId xmlns:a16="http://schemas.microsoft.com/office/drawing/2014/main" id="{0FAF1A5F-74CC-1A5C-0E6C-56740A59B75F}"/>
              </a:ext>
            </a:extLst>
          </p:cNvPr>
          <p:cNvSpPr/>
          <p:nvPr/>
        </p:nvSpPr>
        <p:spPr>
          <a:xfrm rot="5400000">
            <a:off x="2601509" y="772694"/>
            <a:ext cx="36000" cy="982800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" name="テキスト ボックス 8">
            <a:extLst>
              <a:ext uri="{FF2B5EF4-FFF2-40B4-BE49-F238E27FC236}">
                <a16:creationId xmlns:a16="http://schemas.microsoft.com/office/drawing/2014/main" id="{52F0B4F0-FF0F-58D5-896B-DF4360FF206D}"/>
              </a:ext>
            </a:extLst>
          </p:cNvPr>
          <p:cNvSpPr txBox="1"/>
          <p:nvPr/>
        </p:nvSpPr>
        <p:spPr>
          <a:xfrm>
            <a:off x="2311933" y="1304520"/>
            <a:ext cx="274434" cy="2308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ja-JP" altLang="en-US" sz="900"/>
              <a:t>＊</a:t>
            </a:r>
          </a:p>
        </p:txBody>
      </p:sp>
      <p:sp>
        <p:nvSpPr>
          <p:cNvPr id="76" name="左大かっこ 75">
            <a:extLst>
              <a:ext uri="{FF2B5EF4-FFF2-40B4-BE49-F238E27FC236}">
                <a16:creationId xmlns:a16="http://schemas.microsoft.com/office/drawing/2014/main" id="{C9AE18C4-D3F5-9F5E-7826-A8FFA1EA284E}"/>
              </a:ext>
            </a:extLst>
          </p:cNvPr>
          <p:cNvSpPr/>
          <p:nvPr/>
        </p:nvSpPr>
        <p:spPr>
          <a:xfrm rot="5400000">
            <a:off x="2431150" y="1158164"/>
            <a:ext cx="36000" cy="648000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テキスト ボックス 8">
            <a:extLst>
              <a:ext uri="{FF2B5EF4-FFF2-40B4-BE49-F238E27FC236}">
                <a16:creationId xmlns:a16="http://schemas.microsoft.com/office/drawing/2014/main" id="{FE0FB9AE-017E-6AD1-FB6C-B81E85635D08}"/>
              </a:ext>
            </a:extLst>
          </p:cNvPr>
          <p:cNvSpPr txBox="1"/>
          <p:nvPr/>
        </p:nvSpPr>
        <p:spPr>
          <a:xfrm>
            <a:off x="6057366" y="1137530"/>
            <a:ext cx="251671" cy="2308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ja-JP" altLang="en-US" sz="900"/>
              <a:t>＊</a:t>
            </a:r>
          </a:p>
        </p:txBody>
      </p:sp>
      <p:sp>
        <p:nvSpPr>
          <p:cNvPr id="80" name="左大かっこ 79">
            <a:extLst>
              <a:ext uri="{FF2B5EF4-FFF2-40B4-BE49-F238E27FC236}">
                <a16:creationId xmlns:a16="http://schemas.microsoft.com/office/drawing/2014/main" id="{D4EEBF8D-8334-717A-4297-5389132222E6}"/>
              </a:ext>
            </a:extLst>
          </p:cNvPr>
          <p:cNvSpPr/>
          <p:nvPr/>
        </p:nvSpPr>
        <p:spPr>
          <a:xfrm rot="5400000">
            <a:off x="6177190" y="1094248"/>
            <a:ext cx="36000" cy="432000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テキスト ボックス 8">
            <a:extLst>
              <a:ext uri="{FF2B5EF4-FFF2-40B4-BE49-F238E27FC236}">
                <a16:creationId xmlns:a16="http://schemas.microsoft.com/office/drawing/2014/main" id="{4DC14400-33C7-F95D-1378-AE36C1044AE9}"/>
              </a:ext>
            </a:extLst>
          </p:cNvPr>
          <p:cNvSpPr txBox="1"/>
          <p:nvPr/>
        </p:nvSpPr>
        <p:spPr>
          <a:xfrm>
            <a:off x="2155246" y="1908203"/>
            <a:ext cx="229550" cy="20005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700" dirty="0"/>
              <a:t>#</a:t>
            </a:r>
            <a:endParaRPr kumimoji="1" lang="ja-JP" altLang="en-US" sz="700"/>
          </a:p>
        </p:txBody>
      </p:sp>
      <p:sp>
        <p:nvSpPr>
          <p:cNvPr id="82" name="テキスト ボックス 8">
            <a:extLst>
              <a:ext uri="{FF2B5EF4-FFF2-40B4-BE49-F238E27FC236}">
                <a16:creationId xmlns:a16="http://schemas.microsoft.com/office/drawing/2014/main" id="{4886801F-C3B5-0A53-70FD-63081A74A05C}"/>
              </a:ext>
            </a:extLst>
          </p:cNvPr>
          <p:cNvSpPr txBox="1"/>
          <p:nvPr/>
        </p:nvSpPr>
        <p:spPr>
          <a:xfrm>
            <a:off x="2466948" y="1908203"/>
            <a:ext cx="229550" cy="20005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700" dirty="0"/>
              <a:t>#</a:t>
            </a:r>
            <a:endParaRPr kumimoji="1" lang="ja-JP" altLang="en-US" sz="700"/>
          </a:p>
        </p:txBody>
      </p:sp>
      <p:sp>
        <p:nvSpPr>
          <p:cNvPr id="83" name="テキスト ボックス 8">
            <a:extLst>
              <a:ext uri="{FF2B5EF4-FFF2-40B4-BE49-F238E27FC236}">
                <a16:creationId xmlns:a16="http://schemas.microsoft.com/office/drawing/2014/main" id="{CE6EDE19-6643-194F-273D-4D82847C83D2}"/>
              </a:ext>
            </a:extLst>
          </p:cNvPr>
          <p:cNvSpPr txBox="1"/>
          <p:nvPr/>
        </p:nvSpPr>
        <p:spPr>
          <a:xfrm>
            <a:off x="2787567" y="1749546"/>
            <a:ext cx="229550" cy="20005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700" dirty="0"/>
              <a:t>#</a:t>
            </a:r>
            <a:endParaRPr kumimoji="1" lang="ja-JP" altLang="en-US" sz="700"/>
          </a:p>
        </p:txBody>
      </p:sp>
      <p:sp>
        <p:nvSpPr>
          <p:cNvPr id="84" name="テキスト ボックス 8">
            <a:extLst>
              <a:ext uri="{FF2B5EF4-FFF2-40B4-BE49-F238E27FC236}">
                <a16:creationId xmlns:a16="http://schemas.microsoft.com/office/drawing/2014/main" id="{8BAE3AB9-5F70-30E5-C91D-EDA704EB4B9B}"/>
              </a:ext>
            </a:extLst>
          </p:cNvPr>
          <p:cNvSpPr txBox="1"/>
          <p:nvPr/>
        </p:nvSpPr>
        <p:spPr>
          <a:xfrm>
            <a:off x="3099269" y="1570437"/>
            <a:ext cx="229550" cy="20005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700" dirty="0"/>
              <a:t>#</a:t>
            </a:r>
            <a:endParaRPr kumimoji="1" lang="ja-JP" altLang="en-US" sz="700"/>
          </a:p>
        </p:txBody>
      </p:sp>
      <p:sp>
        <p:nvSpPr>
          <p:cNvPr id="85" name="テキスト ボックス 8">
            <a:extLst>
              <a:ext uri="{FF2B5EF4-FFF2-40B4-BE49-F238E27FC236}">
                <a16:creationId xmlns:a16="http://schemas.microsoft.com/office/drawing/2014/main" id="{0FFF76D8-BCB3-1258-F92F-80AE1DB51D6C}"/>
              </a:ext>
            </a:extLst>
          </p:cNvPr>
          <p:cNvSpPr txBox="1"/>
          <p:nvPr/>
        </p:nvSpPr>
        <p:spPr>
          <a:xfrm>
            <a:off x="5542271" y="1901527"/>
            <a:ext cx="229550" cy="20005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700" dirty="0"/>
              <a:t>#</a:t>
            </a:r>
            <a:endParaRPr kumimoji="1" lang="ja-JP" altLang="en-US" sz="700"/>
          </a:p>
        </p:txBody>
      </p:sp>
      <p:sp>
        <p:nvSpPr>
          <p:cNvPr id="86" name="テキスト ボックス 8">
            <a:extLst>
              <a:ext uri="{FF2B5EF4-FFF2-40B4-BE49-F238E27FC236}">
                <a16:creationId xmlns:a16="http://schemas.microsoft.com/office/drawing/2014/main" id="{866924BF-78A4-0778-1C94-8A5492EA0BF7}"/>
              </a:ext>
            </a:extLst>
          </p:cNvPr>
          <p:cNvSpPr txBox="1"/>
          <p:nvPr/>
        </p:nvSpPr>
        <p:spPr>
          <a:xfrm>
            <a:off x="5978605" y="1659167"/>
            <a:ext cx="229550" cy="20005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700" dirty="0"/>
              <a:t>#</a:t>
            </a:r>
            <a:endParaRPr kumimoji="1" lang="ja-JP" altLang="en-US" sz="700"/>
          </a:p>
        </p:txBody>
      </p:sp>
      <p:sp>
        <p:nvSpPr>
          <p:cNvPr id="87" name="テキスト ボックス 8">
            <a:extLst>
              <a:ext uri="{FF2B5EF4-FFF2-40B4-BE49-F238E27FC236}">
                <a16:creationId xmlns:a16="http://schemas.microsoft.com/office/drawing/2014/main" id="{E4B7E03E-692F-8191-6E01-2DD95078C587}"/>
              </a:ext>
            </a:extLst>
          </p:cNvPr>
          <p:cNvSpPr txBox="1"/>
          <p:nvPr/>
        </p:nvSpPr>
        <p:spPr>
          <a:xfrm>
            <a:off x="6419435" y="1448679"/>
            <a:ext cx="229550" cy="20005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700" dirty="0"/>
              <a:t>#</a:t>
            </a:r>
            <a:endParaRPr kumimoji="1" lang="ja-JP" altLang="en-US" sz="700"/>
          </a:p>
        </p:txBody>
      </p:sp>
      <p:sp>
        <p:nvSpPr>
          <p:cNvPr id="17" name="テキスト ボックス 8">
            <a:extLst>
              <a:ext uri="{FF2B5EF4-FFF2-40B4-BE49-F238E27FC236}">
                <a16:creationId xmlns:a16="http://schemas.microsoft.com/office/drawing/2014/main" id="{6D9BA780-270D-C01D-CE95-4E6E9EA07A70}"/>
              </a:ext>
            </a:extLst>
          </p:cNvPr>
          <p:cNvSpPr txBox="1"/>
          <p:nvPr/>
        </p:nvSpPr>
        <p:spPr>
          <a:xfrm>
            <a:off x="4572004" y="1803934"/>
            <a:ext cx="274434" cy="2308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ja-JP" altLang="en-US" sz="900"/>
              <a:t>＊</a:t>
            </a:r>
          </a:p>
        </p:txBody>
      </p:sp>
      <p:sp>
        <p:nvSpPr>
          <p:cNvPr id="18" name="左大かっこ 17">
            <a:extLst>
              <a:ext uri="{FF2B5EF4-FFF2-40B4-BE49-F238E27FC236}">
                <a16:creationId xmlns:a16="http://schemas.microsoft.com/office/drawing/2014/main" id="{0D11AA80-45E1-9A9B-49F6-291D05C80989}"/>
              </a:ext>
            </a:extLst>
          </p:cNvPr>
          <p:cNvSpPr/>
          <p:nvPr/>
        </p:nvSpPr>
        <p:spPr>
          <a:xfrm rot="5400000">
            <a:off x="4700189" y="1558785"/>
            <a:ext cx="36000" cy="864000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テキスト ボックス 8">
            <a:extLst>
              <a:ext uri="{FF2B5EF4-FFF2-40B4-BE49-F238E27FC236}">
                <a16:creationId xmlns:a16="http://schemas.microsoft.com/office/drawing/2014/main" id="{ABC83A29-F26C-EB45-9679-7443749006B5}"/>
              </a:ext>
            </a:extLst>
          </p:cNvPr>
          <p:cNvSpPr txBox="1"/>
          <p:nvPr/>
        </p:nvSpPr>
        <p:spPr>
          <a:xfrm>
            <a:off x="4803613" y="1931595"/>
            <a:ext cx="251671" cy="2308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ja-JP" altLang="en-US" sz="900"/>
              <a:t>＊</a:t>
            </a:r>
          </a:p>
        </p:txBody>
      </p:sp>
      <p:sp>
        <p:nvSpPr>
          <p:cNvPr id="49" name="左大かっこ 48">
            <a:extLst>
              <a:ext uri="{FF2B5EF4-FFF2-40B4-BE49-F238E27FC236}">
                <a16:creationId xmlns:a16="http://schemas.microsoft.com/office/drawing/2014/main" id="{BFC332F5-B43A-808B-E2D1-34BEB7B19826}"/>
              </a:ext>
            </a:extLst>
          </p:cNvPr>
          <p:cNvSpPr/>
          <p:nvPr/>
        </p:nvSpPr>
        <p:spPr>
          <a:xfrm rot="5400000">
            <a:off x="4923437" y="1888313"/>
            <a:ext cx="36000" cy="432000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7" name="テキスト ボックス 8">
            <a:extLst>
              <a:ext uri="{FF2B5EF4-FFF2-40B4-BE49-F238E27FC236}">
                <a16:creationId xmlns:a16="http://schemas.microsoft.com/office/drawing/2014/main" id="{513B5EE9-93DA-185E-A550-2B14CEC7B199}"/>
              </a:ext>
            </a:extLst>
          </p:cNvPr>
          <p:cNvSpPr txBox="1"/>
          <p:nvPr/>
        </p:nvSpPr>
        <p:spPr>
          <a:xfrm>
            <a:off x="2628649" y="1185431"/>
            <a:ext cx="274434" cy="2308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ja-JP" altLang="en-US" sz="900"/>
              <a:t>＊</a:t>
            </a:r>
          </a:p>
        </p:txBody>
      </p:sp>
      <p:sp>
        <p:nvSpPr>
          <p:cNvPr id="199" name="左大かっこ 198">
            <a:extLst>
              <a:ext uri="{FF2B5EF4-FFF2-40B4-BE49-F238E27FC236}">
                <a16:creationId xmlns:a16="http://schemas.microsoft.com/office/drawing/2014/main" id="{62ACDEBA-9845-3782-2D90-A44A62125FA5}"/>
              </a:ext>
            </a:extLst>
          </p:cNvPr>
          <p:cNvSpPr/>
          <p:nvPr/>
        </p:nvSpPr>
        <p:spPr>
          <a:xfrm rot="5400000">
            <a:off x="2749083" y="1029450"/>
            <a:ext cx="36000" cy="648000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2" name="テキスト ボックス 8">
            <a:extLst>
              <a:ext uri="{FF2B5EF4-FFF2-40B4-BE49-F238E27FC236}">
                <a16:creationId xmlns:a16="http://schemas.microsoft.com/office/drawing/2014/main" id="{8B11D794-D801-7107-8DFB-A3F053F381DF}"/>
              </a:ext>
            </a:extLst>
          </p:cNvPr>
          <p:cNvSpPr txBox="1"/>
          <p:nvPr/>
        </p:nvSpPr>
        <p:spPr>
          <a:xfrm>
            <a:off x="2499916" y="1427246"/>
            <a:ext cx="274434" cy="23083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ja-JP" altLang="en-US" sz="900"/>
              <a:t>＊</a:t>
            </a:r>
          </a:p>
        </p:txBody>
      </p:sp>
      <p:sp>
        <p:nvSpPr>
          <p:cNvPr id="203" name="左大かっこ 202">
            <a:extLst>
              <a:ext uri="{FF2B5EF4-FFF2-40B4-BE49-F238E27FC236}">
                <a16:creationId xmlns:a16="http://schemas.microsoft.com/office/drawing/2014/main" id="{CB1651BA-AF06-51A4-06DA-29B2EAF971D3}"/>
              </a:ext>
            </a:extLst>
          </p:cNvPr>
          <p:cNvSpPr/>
          <p:nvPr/>
        </p:nvSpPr>
        <p:spPr>
          <a:xfrm rot="5400000">
            <a:off x="2615515" y="1431164"/>
            <a:ext cx="36000" cy="327244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1BE3B735-8364-C958-A595-6AA8B6DC4A29}"/>
              </a:ext>
            </a:extLst>
          </p:cNvPr>
          <p:cNvSpPr txBox="1"/>
          <p:nvPr/>
        </p:nvSpPr>
        <p:spPr>
          <a:xfrm>
            <a:off x="22716" y="65748"/>
            <a:ext cx="27799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游ゴシック" panose="020B0400000000000000" pitchFamily="50" charset="-128"/>
              </a:rPr>
              <a:t>Supplementary Figure S5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5796D9F-FD12-69C4-62A3-EFFF0C6A034C}"/>
              </a:ext>
            </a:extLst>
          </p:cNvPr>
          <p:cNvSpPr txBox="1"/>
          <p:nvPr/>
        </p:nvSpPr>
        <p:spPr>
          <a:xfrm>
            <a:off x="673200" y="3920486"/>
            <a:ext cx="5511600" cy="2292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rtl="0"/>
            <a:r>
              <a:rPr lang="en-US" altLang="ja-JP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5. 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luorometric intensity of the extracellular DNA treated with various phosphatidylcholines. (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,b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HL-60 cells were differentiated into neutrophil-like cells using 2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ll-trans retinoic acid, and then treated with 0 or 50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M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PMA. Following that, 10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of each phospholipid was added to and incubated with the cells for 2 h. The DNA released into the medium after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Nase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treatment was quantified using 1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YTOX</a:t>
            </a:r>
            <a:r>
              <a:rPr lang="en-US" altLang="ja-JP" sz="11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®︎ 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reen. The data represents mean </a:t>
            </a:r>
            <a:r>
              <a:rPr lang="zh-CN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± 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D from three experiments, which were carried out in duplicates or triplicates. Asterisks indicate statistical significance (*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5), while sharps indicate statistical significance against the corresponding conditions without PMA (#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5). PMA, phorbol 12-myristate 13-acetate; POVPC, 1-palmitoyl-2-(5-oxovaleroyl)-phosphatidylcholine, PGPC, 1-palmitoyl-2-glutaroyl-phosphatidylcholine; PAPC, 1-palmitoyl-2-arachidonoyl-phosphatidylcholine; PLPC, 1-palmitoyl-2-linoleoyl-phospatidylcholine.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AzPC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1-palmitoyl-2-azelaoyl-phospa-tidylcholine.</a:t>
            </a:r>
            <a:endParaRPr lang="ja-JP" altLang="ja-JP" sz="1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61988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9</TotalTime>
  <Words>871</Words>
  <Application>Microsoft Office PowerPoint</Application>
  <PresentationFormat>A4 210 x 297 mm</PresentationFormat>
  <Paragraphs>130</Paragraphs>
  <Slides>6</Slides>
  <Notes>5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3" baseType="lpstr">
      <vt:lpstr>MS PGothic</vt:lpstr>
      <vt:lpstr>游ゴシック</vt:lpstr>
      <vt:lpstr>Arial</vt:lpstr>
      <vt:lpstr>Calibri</vt:lpstr>
      <vt:lpstr>Calibri Light</vt:lpstr>
      <vt:lpstr>Palatino Linotype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瞳 大日方</dc:creator>
  <cp:lastModifiedBy>洋之 板部</cp:lastModifiedBy>
  <cp:revision>34</cp:revision>
  <dcterms:created xsi:type="dcterms:W3CDTF">2022-09-29T12:08:57Z</dcterms:created>
  <dcterms:modified xsi:type="dcterms:W3CDTF">2022-11-04T11:09:36Z</dcterms:modified>
</cp:coreProperties>
</file>